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18"/>
  </p:notesMasterIdLst>
  <p:sldIdLst>
    <p:sldId id="259" r:id="rId2"/>
    <p:sldId id="256" r:id="rId3"/>
    <p:sldId id="382" r:id="rId4"/>
    <p:sldId id="381" r:id="rId5"/>
    <p:sldId id="369" r:id="rId6"/>
    <p:sldId id="279" r:id="rId7"/>
    <p:sldId id="367" r:id="rId8"/>
    <p:sldId id="379" r:id="rId9"/>
    <p:sldId id="350" r:id="rId10"/>
    <p:sldId id="364" r:id="rId11"/>
    <p:sldId id="365" r:id="rId12"/>
    <p:sldId id="366" r:id="rId13"/>
    <p:sldId id="257" r:id="rId14"/>
    <p:sldId id="380" r:id="rId15"/>
    <p:sldId id="384" r:id="rId16"/>
    <p:sldId id="258" r:id="rId17"/>
  </p:sldIdLst>
  <p:sldSz cx="12896850" cy="7254875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75" userDrawn="1">
          <p15:clr>
            <a:srgbClr val="A4A3A4"/>
          </p15:clr>
        </p15:guide>
        <p15:guide id="2" pos="406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920" autoAdjust="0"/>
    <p:restoredTop sz="92997" autoAdjust="0"/>
  </p:normalViewPr>
  <p:slideViewPr>
    <p:cSldViewPr snapToGrid="0">
      <p:cViewPr varScale="1">
        <p:scale>
          <a:sx n="103" d="100"/>
          <a:sy n="103" d="100"/>
        </p:scale>
        <p:origin x="1686" y="114"/>
      </p:cViewPr>
      <p:guideLst>
        <p:guide orient="horz" pos="2875"/>
        <p:guide pos="4062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-1553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fld id="{05FC27C7-2F06-491A-8E6C-61B8533C35F0}" type="datetimeFigureOut">
              <a:rPr lang="he-IL" smtClean="0"/>
              <a:t>י"ד/אלול/תשפ"ד</a:t>
            </a:fld>
            <a:endParaRPr lang="he-I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he-I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fld id="{9582E1F1-7E56-416C-9B77-7E0C990746AE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059200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612106" y="1187315"/>
            <a:ext cx="9672638" cy="2525771"/>
          </a:xfrm>
        </p:spPr>
        <p:txBody>
          <a:bodyPr anchor="b"/>
          <a:lstStyle>
            <a:lvl1pPr algn="ctr">
              <a:defRPr sz="634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12106" y="3810489"/>
            <a:ext cx="9672638" cy="1751582"/>
          </a:xfrm>
        </p:spPr>
        <p:txBody>
          <a:bodyPr/>
          <a:lstStyle>
            <a:lvl1pPr marL="0" indent="0" algn="ctr">
              <a:buNone/>
              <a:defRPr sz="2539"/>
            </a:lvl1pPr>
            <a:lvl2pPr marL="483626" indent="0" algn="ctr">
              <a:buNone/>
              <a:defRPr sz="2116"/>
            </a:lvl2pPr>
            <a:lvl3pPr marL="967252" indent="0" algn="ctr">
              <a:buNone/>
              <a:defRPr sz="1904"/>
            </a:lvl3pPr>
            <a:lvl4pPr marL="1450878" indent="0" algn="ctr">
              <a:buNone/>
              <a:defRPr sz="1692"/>
            </a:lvl4pPr>
            <a:lvl5pPr marL="1934505" indent="0" algn="ctr">
              <a:buNone/>
              <a:defRPr sz="1692"/>
            </a:lvl5pPr>
            <a:lvl6pPr marL="2418131" indent="0" algn="ctr">
              <a:buNone/>
              <a:defRPr sz="1692"/>
            </a:lvl6pPr>
            <a:lvl7pPr marL="2901757" indent="0" algn="ctr">
              <a:buNone/>
              <a:defRPr sz="1692"/>
            </a:lvl7pPr>
            <a:lvl8pPr marL="3385383" indent="0" algn="ctr">
              <a:buNone/>
              <a:defRPr sz="1692"/>
            </a:lvl8pPr>
            <a:lvl9pPr marL="3869009" indent="0" algn="ctr">
              <a:buNone/>
              <a:defRPr sz="1692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920A3-7269-46B6-A2E8-053ABB072C74}" type="datetimeFigureOut">
              <a:rPr lang="he-IL" smtClean="0"/>
              <a:t>י"ד/אלול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4549A-8DA5-4721-A148-1DE6CEB7294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936303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920A3-7269-46B6-A2E8-053ABB072C74}" type="datetimeFigureOut">
              <a:rPr lang="he-IL" smtClean="0"/>
              <a:t>י"ד/אלול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4549A-8DA5-4721-A148-1DE6CEB7294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885663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229308" y="386255"/>
            <a:ext cx="2780883" cy="614817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86659" y="386255"/>
            <a:ext cx="8181439" cy="6148171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920A3-7269-46B6-A2E8-053ABB072C74}" type="datetimeFigureOut">
              <a:rPr lang="he-IL" smtClean="0"/>
              <a:t>י"ד/אלול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4549A-8DA5-4721-A148-1DE6CEB7294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277555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920A3-7269-46B6-A2E8-053ABB072C74}" type="datetimeFigureOut">
              <a:rPr lang="he-IL" smtClean="0"/>
              <a:t>י"ד/אלול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4549A-8DA5-4721-A148-1DE6CEB7294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6487281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79941" y="1808682"/>
            <a:ext cx="11123533" cy="3017826"/>
          </a:xfrm>
        </p:spPr>
        <p:txBody>
          <a:bodyPr anchor="b"/>
          <a:lstStyle>
            <a:lvl1pPr>
              <a:defRPr sz="634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79941" y="4855058"/>
            <a:ext cx="11123533" cy="1587003"/>
          </a:xfrm>
        </p:spPr>
        <p:txBody>
          <a:bodyPr/>
          <a:lstStyle>
            <a:lvl1pPr marL="0" indent="0">
              <a:buNone/>
              <a:defRPr sz="2539">
                <a:solidFill>
                  <a:schemeClr val="tx1">
                    <a:tint val="75000"/>
                  </a:schemeClr>
                </a:solidFill>
              </a:defRPr>
            </a:lvl1pPr>
            <a:lvl2pPr marL="483626" indent="0">
              <a:buNone/>
              <a:defRPr sz="2116">
                <a:solidFill>
                  <a:schemeClr val="tx1">
                    <a:tint val="75000"/>
                  </a:schemeClr>
                </a:solidFill>
              </a:defRPr>
            </a:lvl2pPr>
            <a:lvl3pPr marL="967252" indent="0">
              <a:buNone/>
              <a:defRPr sz="1904">
                <a:solidFill>
                  <a:schemeClr val="tx1">
                    <a:tint val="75000"/>
                  </a:schemeClr>
                </a:solidFill>
              </a:defRPr>
            </a:lvl3pPr>
            <a:lvl4pPr marL="1450878" indent="0">
              <a:buNone/>
              <a:defRPr sz="1692">
                <a:solidFill>
                  <a:schemeClr val="tx1">
                    <a:tint val="75000"/>
                  </a:schemeClr>
                </a:solidFill>
              </a:defRPr>
            </a:lvl4pPr>
            <a:lvl5pPr marL="1934505" indent="0">
              <a:buNone/>
              <a:defRPr sz="1692">
                <a:solidFill>
                  <a:schemeClr val="tx1">
                    <a:tint val="75000"/>
                  </a:schemeClr>
                </a:solidFill>
              </a:defRPr>
            </a:lvl5pPr>
            <a:lvl6pPr marL="2418131" indent="0">
              <a:buNone/>
              <a:defRPr sz="1692">
                <a:solidFill>
                  <a:schemeClr val="tx1">
                    <a:tint val="75000"/>
                  </a:schemeClr>
                </a:solidFill>
              </a:defRPr>
            </a:lvl6pPr>
            <a:lvl7pPr marL="2901757" indent="0">
              <a:buNone/>
              <a:defRPr sz="1692">
                <a:solidFill>
                  <a:schemeClr val="tx1">
                    <a:tint val="75000"/>
                  </a:schemeClr>
                </a:solidFill>
              </a:defRPr>
            </a:lvl7pPr>
            <a:lvl8pPr marL="3385383" indent="0">
              <a:buNone/>
              <a:defRPr sz="1692">
                <a:solidFill>
                  <a:schemeClr val="tx1">
                    <a:tint val="75000"/>
                  </a:schemeClr>
                </a:solidFill>
              </a:defRPr>
            </a:lvl8pPr>
            <a:lvl9pPr marL="3869009" indent="0">
              <a:buNone/>
              <a:defRPr sz="169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920A3-7269-46B6-A2E8-053ABB072C74}" type="datetimeFigureOut">
              <a:rPr lang="he-IL" smtClean="0"/>
              <a:t>י"ד/אלול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4549A-8DA5-4721-A148-1DE6CEB7294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9868675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86659" y="1931274"/>
            <a:ext cx="5481161" cy="460315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529030" y="1931274"/>
            <a:ext cx="5481161" cy="460315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920A3-7269-46B6-A2E8-053ABB072C74}" type="datetimeFigureOut">
              <a:rPr lang="he-IL" smtClean="0"/>
              <a:t>י"ד/אלול/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4549A-8DA5-4721-A148-1DE6CEB7294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851194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8338" y="386255"/>
            <a:ext cx="11123533" cy="140227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8339" y="1778453"/>
            <a:ext cx="5455972" cy="871592"/>
          </a:xfrm>
        </p:spPr>
        <p:txBody>
          <a:bodyPr anchor="b"/>
          <a:lstStyle>
            <a:lvl1pPr marL="0" indent="0">
              <a:buNone/>
              <a:defRPr sz="2539" b="1"/>
            </a:lvl1pPr>
            <a:lvl2pPr marL="483626" indent="0">
              <a:buNone/>
              <a:defRPr sz="2116" b="1"/>
            </a:lvl2pPr>
            <a:lvl3pPr marL="967252" indent="0">
              <a:buNone/>
              <a:defRPr sz="1904" b="1"/>
            </a:lvl3pPr>
            <a:lvl4pPr marL="1450878" indent="0">
              <a:buNone/>
              <a:defRPr sz="1692" b="1"/>
            </a:lvl4pPr>
            <a:lvl5pPr marL="1934505" indent="0">
              <a:buNone/>
              <a:defRPr sz="1692" b="1"/>
            </a:lvl5pPr>
            <a:lvl6pPr marL="2418131" indent="0">
              <a:buNone/>
              <a:defRPr sz="1692" b="1"/>
            </a:lvl6pPr>
            <a:lvl7pPr marL="2901757" indent="0">
              <a:buNone/>
              <a:defRPr sz="1692" b="1"/>
            </a:lvl7pPr>
            <a:lvl8pPr marL="3385383" indent="0">
              <a:buNone/>
              <a:defRPr sz="1692" b="1"/>
            </a:lvl8pPr>
            <a:lvl9pPr marL="3869009" indent="0">
              <a:buNone/>
              <a:defRPr sz="1692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88339" y="2650045"/>
            <a:ext cx="5455972" cy="389781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529030" y="1778453"/>
            <a:ext cx="5482841" cy="871592"/>
          </a:xfrm>
        </p:spPr>
        <p:txBody>
          <a:bodyPr anchor="b"/>
          <a:lstStyle>
            <a:lvl1pPr marL="0" indent="0">
              <a:buNone/>
              <a:defRPr sz="2539" b="1"/>
            </a:lvl1pPr>
            <a:lvl2pPr marL="483626" indent="0">
              <a:buNone/>
              <a:defRPr sz="2116" b="1"/>
            </a:lvl2pPr>
            <a:lvl3pPr marL="967252" indent="0">
              <a:buNone/>
              <a:defRPr sz="1904" b="1"/>
            </a:lvl3pPr>
            <a:lvl4pPr marL="1450878" indent="0">
              <a:buNone/>
              <a:defRPr sz="1692" b="1"/>
            </a:lvl4pPr>
            <a:lvl5pPr marL="1934505" indent="0">
              <a:buNone/>
              <a:defRPr sz="1692" b="1"/>
            </a:lvl5pPr>
            <a:lvl6pPr marL="2418131" indent="0">
              <a:buNone/>
              <a:defRPr sz="1692" b="1"/>
            </a:lvl6pPr>
            <a:lvl7pPr marL="2901757" indent="0">
              <a:buNone/>
              <a:defRPr sz="1692" b="1"/>
            </a:lvl7pPr>
            <a:lvl8pPr marL="3385383" indent="0">
              <a:buNone/>
              <a:defRPr sz="1692" b="1"/>
            </a:lvl8pPr>
            <a:lvl9pPr marL="3869009" indent="0">
              <a:buNone/>
              <a:defRPr sz="1692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529030" y="2650045"/>
            <a:ext cx="5482841" cy="389781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920A3-7269-46B6-A2E8-053ABB072C74}" type="datetimeFigureOut">
              <a:rPr lang="he-IL" smtClean="0"/>
              <a:t>י"ד/אלול/תשפ"ד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4549A-8DA5-4721-A148-1DE6CEB7294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1589371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920A3-7269-46B6-A2E8-053ABB072C74}" type="datetimeFigureOut">
              <a:rPr lang="he-IL" smtClean="0"/>
              <a:t>י"ד/אלול/תשפ"ד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4549A-8DA5-4721-A148-1DE6CEB7294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8854537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920A3-7269-46B6-A2E8-053ABB072C74}" type="datetimeFigureOut">
              <a:rPr lang="he-IL" smtClean="0"/>
              <a:t>י"ד/אלול/תשפ"ד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4549A-8DA5-4721-A148-1DE6CEB7294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661648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8339" y="483658"/>
            <a:ext cx="4159569" cy="1692804"/>
          </a:xfrm>
        </p:spPr>
        <p:txBody>
          <a:bodyPr anchor="b"/>
          <a:lstStyle>
            <a:lvl1pPr>
              <a:defRPr sz="338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482841" y="1044568"/>
            <a:ext cx="6529030" cy="5155663"/>
          </a:xfrm>
        </p:spPr>
        <p:txBody>
          <a:bodyPr/>
          <a:lstStyle>
            <a:lvl1pPr>
              <a:defRPr sz="3385"/>
            </a:lvl1pPr>
            <a:lvl2pPr>
              <a:defRPr sz="2962"/>
            </a:lvl2pPr>
            <a:lvl3pPr>
              <a:defRPr sz="2539"/>
            </a:lvl3pPr>
            <a:lvl4pPr>
              <a:defRPr sz="2116"/>
            </a:lvl4pPr>
            <a:lvl5pPr>
              <a:defRPr sz="2116"/>
            </a:lvl5pPr>
            <a:lvl6pPr>
              <a:defRPr sz="2116"/>
            </a:lvl6pPr>
            <a:lvl7pPr>
              <a:defRPr sz="2116"/>
            </a:lvl7pPr>
            <a:lvl8pPr>
              <a:defRPr sz="2116"/>
            </a:lvl8pPr>
            <a:lvl9pPr>
              <a:defRPr sz="2116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8339" y="2176463"/>
            <a:ext cx="4159569" cy="4032166"/>
          </a:xfrm>
        </p:spPr>
        <p:txBody>
          <a:bodyPr/>
          <a:lstStyle>
            <a:lvl1pPr marL="0" indent="0">
              <a:buNone/>
              <a:defRPr sz="1692"/>
            </a:lvl1pPr>
            <a:lvl2pPr marL="483626" indent="0">
              <a:buNone/>
              <a:defRPr sz="1481"/>
            </a:lvl2pPr>
            <a:lvl3pPr marL="967252" indent="0">
              <a:buNone/>
              <a:defRPr sz="1269"/>
            </a:lvl3pPr>
            <a:lvl4pPr marL="1450878" indent="0">
              <a:buNone/>
              <a:defRPr sz="1058"/>
            </a:lvl4pPr>
            <a:lvl5pPr marL="1934505" indent="0">
              <a:buNone/>
              <a:defRPr sz="1058"/>
            </a:lvl5pPr>
            <a:lvl6pPr marL="2418131" indent="0">
              <a:buNone/>
              <a:defRPr sz="1058"/>
            </a:lvl6pPr>
            <a:lvl7pPr marL="2901757" indent="0">
              <a:buNone/>
              <a:defRPr sz="1058"/>
            </a:lvl7pPr>
            <a:lvl8pPr marL="3385383" indent="0">
              <a:buNone/>
              <a:defRPr sz="1058"/>
            </a:lvl8pPr>
            <a:lvl9pPr marL="3869009" indent="0">
              <a:buNone/>
              <a:defRPr sz="1058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920A3-7269-46B6-A2E8-053ABB072C74}" type="datetimeFigureOut">
              <a:rPr lang="he-IL" smtClean="0"/>
              <a:t>י"ד/אלול/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4549A-8DA5-4721-A148-1DE6CEB7294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592573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8339" y="483658"/>
            <a:ext cx="4159569" cy="1692804"/>
          </a:xfrm>
        </p:spPr>
        <p:txBody>
          <a:bodyPr anchor="b"/>
          <a:lstStyle>
            <a:lvl1pPr>
              <a:defRPr sz="338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482841" y="1044568"/>
            <a:ext cx="6529030" cy="5155663"/>
          </a:xfrm>
        </p:spPr>
        <p:txBody>
          <a:bodyPr anchor="t"/>
          <a:lstStyle>
            <a:lvl1pPr marL="0" indent="0">
              <a:buNone/>
              <a:defRPr sz="3385"/>
            </a:lvl1pPr>
            <a:lvl2pPr marL="483626" indent="0">
              <a:buNone/>
              <a:defRPr sz="2962"/>
            </a:lvl2pPr>
            <a:lvl3pPr marL="967252" indent="0">
              <a:buNone/>
              <a:defRPr sz="2539"/>
            </a:lvl3pPr>
            <a:lvl4pPr marL="1450878" indent="0">
              <a:buNone/>
              <a:defRPr sz="2116"/>
            </a:lvl4pPr>
            <a:lvl5pPr marL="1934505" indent="0">
              <a:buNone/>
              <a:defRPr sz="2116"/>
            </a:lvl5pPr>
            <a:lvl6pPr marL="2418131" indent="0">
              <a:buNone/>
              <a:defRPr sz="2116"/>
            </a:lvl6pPr>
            <a:lvl7pPr marL="2901757" indent="0">
              <a:buNone/>
              <a:defRPr sz="2116"/>
            </a:lvl7pPr>
            <a:lvl8pPr marL="3385383" indent="0">
              <a:buNone/>
              <a:defRPr sz="2116"/>
            </a:lvl8pPr>
            <a:lvl9pPr marL="3869009" indent="0">
              <a:buNone/>
              <a:defRPr sz="211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8339" y="2176463"/>
            <a:ext cx="4159569" cy="4032166"/>
          </a:xfrm>
        </p:spPr>
        <p:txBody>
          <a:bodyPr/>
          <a:lstStyle>
            <a:lvl1pPr marL="0" indent="0">
              <a:buNone/>
              <a:defRPr sz="1692"/>
            </a:lvl1pPr>
            <a:lvl2pPr marL="483626" indent="0">
              <a:buNone/>
              <a:defRPr sz="1481"/>
            </a:lvl2pPr>
            <a:lvl3pPr marL="967252" indent="0">
              <a:buNone/>
              <a:defRPr sz="1269"/>
            </a:lvl3pPr>
            <a:lvl4pPr marL="1450878" indent="0">
              <a:buNone/>
              <a:defRPr sz="1058"/>
            </a:lvl4pPr>
            <a:lvl5pPr marL="1934505" indent="0">
              <a:buNone/>
              <a:defRPr sz="1058"/>
            </a:lvl5pPr>
            <a:lvl6pPr marL="2418131" indent="0">
              <a:buNone/>
              <a:defRPr sz="1058"/>
            </a:lvl6pPr>
            <a:lvl7pPr marL="2901757" indent="0">
              <a:buNone/>
              <a:defRPr sz="1058"/>
            </a:lvl7pPr>
            <a:lvl8pPr marL="3385383" indent="0">
              <a:buNone/>
              <a:defRPr sz="1058"/>
            </a:lvl8pPr>
            <a:lvl9pPr marL="3869009" indent="0">
              <a:buNone/>
              <a:defRPr sz="1058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920A3-7269-46B6-A2E8-053ABB072C74}" type="datetimeFigureOut">
              <a:rPr lang="he-IL" smtClean="0"/>
              <a:t>י"ד/אלול/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4549A-8DA5-4721-A148-1DE6CEB7294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4685885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86659" y="386255"/>
            <a:ext cx="11123533" cy="140227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6659" y="1931274"/>
            <a:ext cx="11123533" cy="460315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86659" y="6724195"/>
            <a:ext cx="2901791" cy="3862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4920A3-7269-46B6-A2E8-053ABB072C74}" type="datetimeFigureOut">
              <a:rPr lang="he-IL" smtClean="0"/>
              <a:t>י"ד/אלול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72082" y="6724195"/>
            <a:ext cx="4352687" cy="3862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108400" y="6724195"/>
            <a:ext cx="2901791" cy="3862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84549A-8DA5-4721-A148-1DE6CEB7294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737808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67252" rtl="0" eaLnBrk="1" latinLnBrk="0" hangingPunct="1">
        <a:lnSpc>
          <a:spcPct val="90000"/>
        </a:lnSpc>
        <a:spcBef>
          <a:spcPct val="0"/>
        </a:spcBef>
        <a:buNone/>
        <a:defRPr sz="465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1813" indent="-241813" algn="l" defTabSz="967252" rtl="0" eaLnBrk="1" latinLnBrk="0" hangingPunct="1">
        <a:lnSpc>
          <a:spcPct val="90000"/>
        </a:lnSpc>
        <a:spcBef>
          <a:spcPts val="1058"/>
        </a:spcBef>
        <a:buFont typeface="Arial" panose="020B0604020202020204" pitchFamily="34" charset="0"/>
        <a:buChar char="•"/>
        <a:defRPr sz="2962" kern="1200">
          <a:solidFill>
            <a:schemeClr val="tx1"/>
          </a:solidFill>
          <a:latin typeface="+mn-lt"/>
          <a:ea typeface="+mn-ea"/>
          <a:cs typeface="+mn-cs"/>
        </a:defRPr>
      </a:lvl1pPr>
      <a:lvl2pPr marL="725439" indent="-241813" algn="l" defTabSz="967252" rtl="0" eaLnBrk="1" latinLnBrk="0" hangingPunct="1">
        <a:lnSpc>
          <a:spcPct val="90000"/>
        </a:lnSpc>
        <a:spcBef>
          <a:spcPts val="529"/>
        </a:spcBef>
        <a:buFont typeface="Arial" panose="020B0604020202020204" pitchFamily="34" charset="0"/>
        <a:buChar char="•"/>
        <a:defRPr sz="2539" kern="1200">
          <a:solidFill>
            <a:schemeClr val="tx1"/>
          </a:solidFill>
          <a:latin typeface="+mn-lt"/>
          <a:ea typeface="+mn-ea"/>
          <a:cs typeface="+mn-cs"/>
        </a:defRPr>
      </a:lvl2pPr>
      <a:lvl3pPr marL="1209065" indent="-241813" algn="l" defTabSz="967252" rtl="0" eaLnBrk="1" latinLnBrk="0" hangingPunct="1">
        <a:lnSpc>
          <a:spcPct val="90000"/>
        </a:lnSpc>
        <a:spcBef>
          <a:spcPts val="529"/>
        </a:spcBef>
        <a:buFont typeface="Arial" panose="020B0604020202020204" pitchFamily="34" charset="0"/>
        <a:buChar char="•"/>
        <a:defRPr sz="2116" kern="1200">
          <a:solidFill>
            <a:schemeClr val="tx1"/>
          </a:solidFill>
          <a:latin typeface="+mn-lt"/>
          <a:ea typeface="+mn-ea"/>
          <a:cs typeface="+mn-cs"/>
        </a:defRPr>
      </a:lvl3pPr>
      <a:lvl4pPr marL="1692692" indent="-241813" algn="l" defTabSz="967252" rtl="0" eaLnBrk="1" latinLnBrk="0" hangingPunct="1">
        <a:lnSpc>
          <a:spcPct val="90000"/>
        </a:lnSpc>
        <a:spcBef>
          <a:spcPts val="529"/>
        </a:spcBef>
        <a:buFont typeface="Arial" panose="020B0604020202020204" pitchFamily="34" charset="0"/>
        <a:buChar char="•"/>
        <a:defRPr sz="1904" kern="1200">
          <a:solidFill>
            <a:schemeClr val="tx1"/>
          </a:solidFill>
          <a:latin typeface="+mn-lt"/>
          <a:ea typeface="+mn-ea"/>
          <a:cs typeface="+mn-cs"/>
        </a:defRPr>
      </a:lvl4pPr>
      <a:lvl5pPr marL="2176318" indent="-241813" algn="l" defTabSz="967252" rtl="0" eaLnBrk="1" latinLnBrk="0" hangingPunct="1">
        <a:lnSpc>
          <a:spcPct val="90000"/>
        </a:lnSpc>
        <a:spcBef>
          <a:spcPts val="529"/>
        </a:spcBef>
        <a:buFont typeface="Arial" panose="020B0604020202020204" pitchFamily="34" charset="0"/>
        <a:buChar char="•"/>
        <a:defRPr sz="1904" kern="1200">
          <a:solidFill>
            <a:schemeClr val="tx1"/>
          </a:solidFill>
          <a:latin typeface="+mn-lt"/>
          <a:ea typeface="+mn-ea"/>
          <a:cs typeface="+mn-cs"/>
        </a:defRPr>
      </a:lvl5pPr>
      <a:lvl6pPr marL="2659944" indent="-241813" algn="l" defTabSz="967252" rtl="0" eaLnBrk="1" latinLnBrk="0" hangingPunct="1">
        <a:lnSpc>
          <a:spcPct val="90000"/>
        </a:lnSpc>
        <a:spcBef>
          <a:spcPts val="529"/>
        </a:spcBef>
        <a:buFont typeface="Arial" panose="020B0604020202020204" pitchFamily="34" charset="0"/>
        <a:buChar char="•"/>
        <a:defRPr sz="1904" kern="1200">
          <a:solidFill>
            <a:schemeClr val="tx1"/>
          </a:solidFill>
          <a:latin typeface="+mn-lt"/>
          <a:ea typeface="+mn-ea"/>
          <a:cs typeface="+mn-cs"/>
        </a:defRPr>
      </a:lvl6pPr>
      <a:lvl7pPr marL="3143570" indent="-241813" algn="l" defTabSz="967252" rtl="0" eaLnBrk="1" latinLnBrk="0" hangingPunct="1">
        <a:lnSpc>
          <a:spcPct val="90000"/>
        </a:lnSpc>
        <a:spcBef>
          <a:spcPts val="529"/>
        </a:spcBef>
        <a:buFont typeface="Arial" panose="020B0604020202020204" pitchFamily="34" charset="0"/>
        <a:buChar char="•"/>
        <a:defRPr sz="1904" kern="1200">
          <a:solidFill>
            <a:schemeClr val="tx1"/>
          </a:solidFill>
          <a:latin typeface="+mn-lt"/>
          <a:ea typeface="+mn-ea"/>
          <a:cs typeface="+mn-cs"/>
        </a:defRPr>
      </a:lvl7pPr>
      <a:lvl8pPr marL="3627196" indent="-241813" algn="l" defTabSz="967252" rtl="0" eaLnBrk="1" latinLnBrk="0" hangingPunct="1">
        <a:lnSpc>
          <a:spcPct val="90000"/>
        </a:lnSpc>
        <a:spcBef>
          <a:spcPts val="529"/>
        </a:spcBef>
        <a:buFont typeface="Arial" panose="020B0604020202020204" pitchFamily="34" charset="0"/>
        <a:buChar char="•"/>
        <a:defRPr sz="1904" kern="1200">
          <a:solidFill>
            <a:schemeClr val="tx1"/>
          </a:solidFill>
          <a:latin typeface="+mn-lt"/>
          <a:ea typeface="+mn-ea"/>
          <a:cs typeface="+mn-cs"/>
        </a:defRPr>
      </a:lvl8pPr>
      <a:lvl9pPr marL="4110822" indent="-241813" algn="l" defTabSz="967252" rtl="0" eaLnBrk="1" latinLnBrk="0" hangingPunct="1">
        <a:lnSpc>
          <a:spcPct val="90000"/>
        </a:lnSpc>
        <a:spcBef>
          <a:spcPts val="529"/>
        </a:spcBef>
        <a:buFont typeface="Arial" panose="020B0604020202020204" pitchFamily="34" charset="0"/>
        <a:buChar char="•"/>
        <a:defRPr sz="190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7252" rtl="0" eaLnBrk="1" latinLnBrk="0" hangingPunct="1">
        <a:defRPr sz="1904" kern="1200">
          <a:solidFill>
            <a:schemeClr val="tx1"/>
          </a:solidFill>
          <a:latin typeface="+mn-lt"/>
          <a:ea typeface="+mn-ea"/>
          <a:cs typeface="+mn-cs"/>
        </a:defRPr>
      </a:lvl1pPr>
      <a:lvl2pPr marL="483626" algn="l" defTabSz="967252" rtl="0" eaLnBrk="1" latinLnBrk="0" hangingPunct="1">
        <a:defRPr sz="1904" kern="1200">
          <a:solidFill>
            <a:schemeClr val="tx1"/>
          </a:solidFill>
          <a:latin typeface="+mn-lt"/>
          <a:ea typeface="+mn-ea"/>
          <a:cs typeface="+mn-cs"/>
        </a:defRPr>
      </a:lvl2pPr>
      <a:lvl3pPr marL="967252" algn="l" defTabSz="967252" rtl="0" eaLnBrk="1" latinLnBrk="0" hangingPunct="1">
        <a:defRPr sz="1904" kern="1200">
          <a:solidFill>
            <a:schemeClr val="tx1"/>
          </a:solidFill>
          <a:latin typeface="+mn-lt"/>
          <a:ea typeface="+mn-ea"/>
          <a:cs typeface="+mn-cs"/>
        </a:defRPr>
      </a:lvl3pPr>
      <a:lvl4pPr marL="1450878" algn="l" defTabSz="967252" rtl="0" eaLnBrk="1" latinLnBrk="0" hangingPunct="1">
        <a:defRPr sz="1904" kern="1200">
          <a:solidFill>
            <a:schemeClr val="tx1"/>
          </a:solidFill>
          <a:latin typeface="+mn-lt"/>
          <a:ea typeface="+mn-ea"/>
          <a:cs typeface="+mn-cs"/>
        </a:defRPr>
      </a:lvl4pPr>
      <a:lvl5pPr marL="1934505" algn="l" defTabSz="967252" rtl="0" eaLnBrk="1" latinLnBrk="0" hangingPunct="1">
        <a:defRPr sz="1904" kern="1200">
          <a:solidFill>
            <a:schemeClr val="tx1"/>
          </a:solidFill>
          <a:latin typeface="+mn-lt"/>
          <a:ea typeface="+mn-ea"/>
          <a:cs typeface="+mn-cs"/>
        </a:defRPr>
      </a:lvl5pPr>
      <a:lvl6pPr marL="2418131" algn="l" defTabSz="967252" rtl="0" eaLnBrk="1" latinLnBrk="0" hangingPunct="1">
        <a:defRPr sz="1904" kern="1200">
          <a:solidFill>
            <a:schemeClr val="tx1"/>
          </a:solidFill>
          <a:latin typeface="+mn-lt"/>
          <a:ea typeface="+mn-ea"/>
          <a:cs typeface="+mn-cs"/>
        </a:defRPr>
      </a:lvl6pPr>
      <a:lvl7pPr marL="2901757" algn="l" defTabSz="967252" rtl="0" eaLnBrk="1" latinLnBrk="0" hangingPunct="1">
        <a:defRPr sz="1904" kern="1200">
          <a:solidFill>
            <a:schemeClr val="tx1"/>
          </a:solidFill>
          <a:latin typeface="+mn-lt"/>
          <a:ea typeface="+mn-ea"/>
          <a:cs typeface="+mn-cs"/>
        </a:defRPr>
      </a:lvl7pPr>
      <a:lvl8pPr marL="3385383" algn="l" defTabSz="967252" rtl="0" eaLnBrk="1" latinLnBrk="0" hangingPunct="1">
        <a:defRPr sz="1904" kern="1200">
          <a:solidFill>
            <a:schemeClr val="tx1"/>
          </a:solidFill>
          <a:latin typeface="+mn-lt"/>
          <a:ea typeface="+mn-ea"/>
          <a:cs typeface="+mn-cs"/>
        </a:defRPr>
      </a:lvl8pPr>
      <a:lvl9pPr marL="3869009" algn="l" defTabSz="967252" rtl="0" eaLnBrk="1" latinLnBrk="0" hangingPunct="1">
        <a:defRPr sz="190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3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6.png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emf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emf"/><Relationship Id="rId2" Type="http://schemas.openxmlformats.org/officeDocument/2006/relationships/image" Target="../media/image28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0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3.emf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jp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emf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5" Type="http://schemas.openxmlformats.org/officeDocument/2006/relationships/image" Target="../media/image13.emf"/><Relationship Id="rId4" Type="http://schemas.openxmlformats.org/officeDocument/2006/relationships/image" Target="../media/image1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tangle 13">
            <a:extLst>
              <a:ext uri="{FF2B5EF4-FFF2-40B4-BE49-F238E27FC236}">
                <a16:creationId xmlns:a16="http://schemas.microsoft.com/office/drawing/2014/main" id="{6FD982AC-1D1A-3AF1-953F-79352B1BC07E}"/>
              </a:ext>
            </a:extLst>
          </p:cNvPr>
          <p:cNvSpPr/>
          <p:nvPr/>
        </p:nvSpPr>
        <p:spPr>
          <a:xfrm>
            <a:off x="6144658" y="2777821"/>
            <a:ext cx="705507" cy="1423335"/>
          </a:xfrm>
          <a:prstGeom prst="rect">
            <a:avLst/>
          </a:prstGeom>
          <a:solidFill>
            <a:srgbClr val="FFFF00">
              <a:alpha val="34000"/>
            </a:srgbClr>
          </a:solidFill>
          <a:ln w="285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L" dirty="0">
              <a:highlight>
                <a:srgbClr val="FFFF00"/>
              </a:highlight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09221E3-184A-4CD0-9CE1-216E32D0DE34}"/>
              </a:ext>
            </a:extLst>
          </p:cNvPr>
          <p:cNvSpPr txBox="1"/>
          <p:nvPr/>
        </p:nvSpPr>
        <p:spPr>
          <a:xfrm>
            <a:off x="0" y="0"/>
            <a:ext cx="124264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</a:t>
            </a:r>
            <a:endParaRPr lang="en-IL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33F3F944-A010-4D7D-8728-573022085C9F}"/>
              </a:ext>
            </a:extLst>
          </p:cNvPr>
          <p:cNvGrpSpPr/>
          <p:nvPr/>
        </p:nvGrpSpPr>
        <p:grpSpPr>
          <a:xfrm>
            <a:off x="701990" y="473188"/>
            <a:ext cx="12089952" cy="5825713"/>
            <a:chOff x="701990" y="473188"/>
            <a:chExt cx="12089952" cy="5825713"/>
          </a:xfrm>
        </p:grpSpPr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8D82515A-2C65-F78E-1C8E-6718C874DF8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01990" y="862901"/>
              <a:ext cx="12089952" cy="5436000"/>
            </a:xfrm>
            <a:prstGeom prst="rect">
              <a:avLst/>
            </a:prstGeom>
          </p:spPr>
        </p:pic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059271B2-BE6C-8E68-B76A-4268DAD9932E}"/>
                </a:ext>
              </a:extLst>
            </p:cNvPr>
            <p:cNvSpPr/>
            <p:nvPr/>
          </p:nvSpPr>
          <p:spPr>
            <a:xfrm>
              <a:off x="9672488" y="873298"/>
              <a:ext cx="108000" cy="1423336"/>
            </a:xfrm>
            <a:prstGeom prst="rect">
              <a:avLst/>
            </a:prstGeom>
            <a:noFill/>
            <a:ln w="19050">
              <a:prstDash val="solid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 sz="1904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CC96CEA9-4587-4B76-9E8B-1E58EDC0BA55}"/>
                </a:ext>
              </a:extLst>
            </p:cNvPr>
            <p:cNvSpPr txBox="1"/>
            <p:nvPr/>
          </p:nvSpPr>
          <p:spPr>
            <a:xfrm>
              <a:off x="10641831" y="2552581"/>
              <a:ext cx="5693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FF3399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106R</a:t>
              </a:r>
              <a:endParaRPr lang="en-IL" sz="1000" b="1" i="1" dirty="0">
                <a:solidFill>
                  <a:srgbClr val="FF3399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2070BF8F-65D5-4A7E-84B2-A907C2B9DF0A}"/>
                </a:ext>
              </a:extLst>
            </p:cNvPr>
            <p:cNvSpPr txBox="1"/>
            <p:nvPr/>
          </p:nvSpPr>
          <p:spPr>
            <a:xfrm>
              <a:off x="9523548" y="473188"/>
              <a:ext cx="40588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37</a:t>
              </a:r>
            </a:p>
            <a:p>
              <a:pPr algn="ctr"/>
              <a:r>
                <a:rPr lang="en-US" sz="1000" b="1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/D</a:t>
              </a:r>
              <a:endParaRPr lang="en-IL" sz="1000" b="1" i="1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DA8F53C3-95EC-43C9-A5F1-F1FCE638B2FD}"/>
                </a:ext>
              </a:extLst>
            </p:cNvPr>
            <p:cNvSpPr txBox="1"/>
            <p:nvPr/>
          </p:nvSpPr>
          <p:spPr>
            <a:xfrm>
              <a:off x="9952197" y="478387"/>
              <a:ext cx="41229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FF3399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41</a:t>
              </a:r>
            </a:p>
            <a:p>
              <a:pPr algn="ctr"/>
              <a:r>
                <a:rPr lang="en-US" sz="1000" b="1" dirty="0">
                  <a:solidFill>
                    <a:srgbClr val="FF3399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/R</a:t>
              </a:r>
              <a:endParaRPr lang="en-IL" sz="1000" b="1" i="1" dirty="0">
                <a:solidFill>
                  <a:srgbClr val="FF3399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92013DB3-9FA3-03BA-5ACA-3FC48BFBEC44}"/>
                </a:ext>
              </a:extLst>
            </p:cNvPr>
            <p:cNvSpPr/>
            <p:nvPr/>
          </p:nvSpPr>
          <p:spPr>
            <a:xfrm>
              <a:off x="10104343" y="873298"/>
              <a:ext cx="108000" cy="1423336"/>
            </a:xfrm>
            <a:prstGeom prst="rect">
              <a:avLst/>
            </a:prstGeom>
            <a:noFill/>
            <a:ln w="19050">
              <a:prstDash val="solid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 sz="1904"/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06825024-FC88-1B54-2ED5-8DE7BFC874F3}"/>
                </a:ext>
              </a:extLst>
            </p:cNvPr>
            <p:cNvSpPr/>
            <p:nvPr/>
          </p:nvSpPr>
          <p:spPr>
            <a:xfrm>
              <a:off x="10872524" y="2758021"/>
              <a:ext cx="108000" cy="1423336"/>
            </a:xfrm>
            <a:prstGeom prst="rect">
              <a:avLst/>
            </a:prstGeom>
            <a:noFill/>
            <a:ln w="19050">
              <a:prstDash val="solid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 sz="1904"/>
            </a:p>
          </p:txBody>
        </p:sp>
      </p:grpSp>
      <p:sp>
        <p:nvSpPr>
          <p:cNvPr id="3" name="Rectangle 2">
            <a:extLst>
              <a:ext uri="{FF2B5EF4-FFF2-40B4-BE49-F238E27FC236}">
                <a16:creationId xmlns:a16="http://schemas.microsoft.com/office/drawing/2014/main" id="{FB8105C7-ED4D-4E90-98D0-9BA682F82502}"/>
              </a:ext>
            </a:extLst>
          </p:cNvPr>
          <p:cNvSpPr/>
          <p:nvPr/>
        </p:nvSpPr>
        <p:spPr>
          <a:xfrm>
            <a:off x="7031678" y="5838780"/>
            <a:ext cx="4188249" cy="216000"/>
          </a:xfrm>
          <a:prstGeom prst="rect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L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41EFC8A6-E32C-4A1F-B936-B8782D7705FF}"/>
              </a:ext>
            </a:extLst>
          </p:cNvPr>
          <p:cNvSpPr/>
          <p:nvPr/>
        </p:nvSpPr>
        <p:spPr>
          <a:xfrm>
            <a:off x="7340387" y="6309298"/>
            <a:ext cx="362939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>
                <a:solidFill>
                  <a:srgbClr val="00206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-terminal 38 aa ABR binding domain </a:t>
            </a:r>
            <a:endParaRPr lang="en-IL" sz="1600" b="1" dirty="0">
              <a:solidFill>
                <a:srgbClr val="00206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C73AEA81-529E-4425-AEFA-95D52CB5CBEE}"/>
              </a:ext>
            </a:extLst>
          </p:cNvPr>
          <p:cNvCxnSpPr/>
          <p:nvPr/>
        </p:nvCxnSpPr>
        <p:spPr>
          <a:xfrm>
            <a:off x="7048433" y="6325746"/>
            <a:ext cx="4137318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Rectangle 3">
            <a:extLst>
              <a:ext uri="{FF2B5EF4-FFF2-40B4-BE49-F238E27FC236}">
                <a16:creationId xmlns:a16="http://schemas.microsoft.com/office/drawing/2014/main" id="{3E2F9C0D-8052-8AAE-48A9-0399BC04336F}"/>
              </a:ext>
            </a:extLst>
          </p:cNvPr>
          <p:cNvSpPr/>
          <p:nvPr/>
        </p:nvSpPr>
        <p:spPr>
          <a:xfrm>
            <a:off x="6474304" y="2758020"/>
            <a:ext cx="144000" cy="1423335"/>
          </a:xfrm>
          <a:prstGeom prst="rect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L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C496D27-1D93-E577-597B-BA5199A525A1}"/>
              </a:ext>
            </a:extLst>
          </p:cNvPr>
          <p:cNvSpPr txBox="1"/>
          <p:nvPr/>
        </p:nvSpPr>
        <p:spPr>
          <a:xfrm>
            <a:off x="6307387" y="2552581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68A</a:t>
            </a:r>
            <a:endParaRPr lang="en-IL" sz="1000" b="1" i="1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EAEB4798-89C7-1CD5-022B-622C9FC876DC}"/>
              </a:ext>
            </a:extLst>
          </p:cNvPr>
          <p:cNvSpPr/>
          <p:nvPr/>
        </p:nvSpPr>
        <p:spPr>
          <a:xfrm>
            <a:off x="5278835" y="4344390"/>
            <a:ext cx="311816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>
                <a:solidFill>
                  <a:srgbClr val="00206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hosphoinositide-binding domain</a:t>
            </a:r>
            <a:endParaRPr lang="en-IL" sz="1600" b="1" dirty="0">
              <a:solidFill>
                <a:srgbClr val="00206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DC6A4397-340D-325C-4E4F-1F94EC9FEAB5}"/>
              </a:ext>
            </a:extLst>
          </p:cNvPr>
          <p:cNvCxnSpPr>
            <a:cxnSpLocks/>
          </p:cNvCxnSpPr>
          <p:nvPr/>
        </p:nvCxnSpPr>
        <p:spPr>
          <a:xfrm>
            <a:off x="6164575" y="4415444"/>
            <a:ext cx="641667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Rectangle 19">
            <a:extLst>
              <a:ext uri="{FF2B5EF4-FFF2-40B4-BE49-F238E27FC236}">
                <a16:creationId xmlns:a16="http://schemas.microsoft.com/office/drawing/2014/main" id="{BC859BB3-1F8B-4EE0-83CA-B6723E8AFE62}"/>
              </a:ext>
            </a:extLst>
          </p:cNvPr>
          <p:cNvSpPr/>
          <p:nvPr/>
        </p:nvSpPr>
        <p:spPr>
          <a:xfrm>
            <a:off x="8886083" y="2418827"/>
            <a:ext cx="198644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 err="1">
                <a:solidFill>
                  <a:srgbClr val="00206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ab</a:t>
            </a:r>
            <a:r>
              <a:rPr lang="en-US" sz="1600" b="1" dirty="0">
                <a:solidFill>
                  <a:srgbClr val="00206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inding domain</a:t>
            </a:r>
            <a:endParaRPr lang="en-IL" sz="1600" b="1" dirty="0">
              <a:solidFill>
                <a:srgbClr val="00206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673CCB5B-816F-4187-8838-8BEB3A17773D}"/>
              </a:ext>
            </a:extLst>
          </p:cNvPr>
          <p:cNvCxnSpPr>
            <a:cxnSpLocks/>
          </p:cNvCxnSpPr>
          <p:nvPr/>
        </p:nvCxnSpPr>
        <p:spPr>
          <a:xfrm>
            <a:off x="9606879" y="2496260"/>
            <a:ext cx="641667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7626407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08" name="Straight Connector 907">
            <a:extLst>
              <a:ext uri="{FF2B5EF4-FFF2-40B4-BE49-F238E27FC236}">
                <a16:creationId xmlns:a16="http://schemas.microsoft.com/office/drawing/2014/main" id="{997DBE96-7D12-5EFB-FE74-6FB1CCBD11D8}"/>
              </a:ext>
            </a:extLst>
          </p:cNvPr>
          <p:cNvCxnSpPr>
            <a:cxnSpLocks/>
          </p:cNvCxnSpPr>
          <p:nvPr/>
        </p:nvCxnSpPr>
        <p:spPr>
          <a:xfrm>
            <a:off x="3300366" y="7574176"/>
            <a:ext cx="9974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3" name="Straight Connector 912">
            <a:extLst>
              <a:ext uri="{FF2B5EF4-FFF2-40B4-BE49-F238E27FC236}">
                <a16:creationId xmlns:a16="http://schemas.microsoft.com/office/drawing/2014/main" id="{231E034A-77E6-F2B0-48C3-CEB1C20542D9}"/>
              </a:ext>
            </a:extLst>
          </p:cNvPr>
          <p:cNvCxnSpPr>
            <a:cxnSpLocks/>
          </p:cNvCxnSpPr>
          <p:nvPr/>
        </p:nvCxnSpPr>
        <p:spPr>
          <a:xfrm>
            <a:off x="8586941" y="3667093"/>
            <a:ext cx="9974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5" name="Straight Connector 914">
            <a:extLst>
              <a:ext uri="{FF2B5EF4-FFF2-40B4-BE49-F238E27FC236}">
                <a16:creationId xmlns:a16="http://schemas.microsoft.com/office/drawing/2014/main" id="{BEC527A3-A286-A495-8B6D-1DFDAA500FB2}"/>
              </a:ext>
            </a:extLst>
          </p:cNvPr>
          <p:cNvCxnSpPr>
            <a:cxnSpLocks/>
          </p:cNvCxnSpPr>
          <p:nvPr/>
        </p:nvCxnSpPr>
        <p:spPr>
          <a:xfrm>
            <a:off x="8593609" y="6167240"/>
            <a:ext cx="9974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6" name="Straight Connector 915">
            <a:extLst>
              <a:ext uri="{FF2B5EF4-FFF2-40B4-BE49-F238E27FC236}">
                <a16:creationId xmlns:a16="http://schemas.microsoft.com/office/drawing/2014/main" id="{AB4A7276-3A10-6009-A0F7-98320508EFCE}"/>
              </a:ext>
            </a:extLst>
          </p:cNvPr>
          <p:cNvCxnSpPr>
            <a:cxnSpLocks/>
          </p:cNvCxnSpPr>
          <p:nvPr/>
        </p:nvCxnSpPr>
        <p:spPr>
          <a:xfrm>
            <a:off x="8586940" y="7467318"/>
            <a:ext cx="9974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C503FC45-F03A-DC05-DD8F-0DE27B9EAFE3}"/>
              </a:ext>
            </a:extLst>
          </p:cNvPr>
          <p:cNvSpPr txBox="1"/>
          <p:nvPr/>
        </p:nvSpPr>
        <p:spPr>
          <a:xfrm>
            <a:off x="1585504" y="833087"/>
            <a:ext cx="21152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itchFamily="18" charset="0"/>
              </a:rPr>
              <a:t>∆</a:t>
            </a:r>
            <a:r>
              <a:rPr lang="en-US" b="1" i="1" dirty="0" err="1">
                <a:latin typeface="Times New Roman" panose="02020603050405020304" pitchFamily="18" charset="0"/>
                <a:cs typeface="Times New Roman" pitchFamily="18" charset="0"/>
              </a:rPr>
              <a:t>esp</a:t>
            </a:r>
            <a:r>
              <a:rPr lang="en-US" b="1" dirty="0" err="1">
                <a:latin typeface="Times New Roman" panose="02020603050405020304" pitchFamily="18" charset="0"/>
                <a:cs typeface="Times New Roman" pitchFamily="18" charset="0"/>
              </a:rPr>
              <a:t>H</a:t>
            </a:r>
            <a:r>
              <a:rPr lang="en-US" b="1" dirty="0">
                <a:latin typeface="Times New Roman" panose="02020603050405020304" pitchFamily="18" charset="0"/>
                <a:cs typeface="Times New Roman" pitchFamily="18" charset="0"/>
              </a:rPr>
              <a:t>/pEspH</a:t>
            </a:r>
            <a:r>
              <a:rPr lang="en-US" b="1" i="1" baseline="-25000" dirty="0">
                <a:latin typeface="Times New Roman" panose="02020603050405020304" pitchFamily="18" charset="0"/>
                <a:cs typeface="Times New Roman" pitchFamily="18" charset="0"/>
              </a:rPr>
              <a:t>K106R</a:t>
            </a:r>
            <a:endParaRPr lang="en-US" b="1" baseline="-25000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60C59C3-7F12-0389-45A6-F48D40D3F9B0}"/>
              </a:ext>
            </a:extLst>
          </p:cNvPr>
          <p:cNvSpPr txBox="1"/>
          <p:nvPr/>
        </p:nvSpPr>
        <p:spPr>
          <a:xfrm>
            <a:off x="7726455" y="833087"/>
            <a:ext cx="19337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itchFamily="18" charset="0"/>
              </a:rPr>
              <a:t>∆</a:t>
            </a:r>
            <a:r>
              <a:rPr lang="en-US" b="1" i="1" dirty="0" err="1">
                <a:latin typeface="Times New Roman" panose="02020603050405020304" pitchFamily="18" charset="0"/>
                <a:cs typeface="Times New Roman" pitchFamily="18" charset="0"/>
              </a:rPr>
              <a:t>esp</a:t>
            </a:r>
            <a:r>
              <a:rPr lang="en-US" b="1" dirty="0" err="1">
                <a:latin typeface="Times New Roman" panose="02020603050405020304" pitchFamily="18" charset="0"/>
                <a:cs typeface="Times New Roman" pitchFamily="18" charset="0"/>
              </a:rPr>
              <a:t>H</a:t>
            </a:r>
            <a:r>
              <a:rPr lang="en-US" b="1" dirty="0">
                <a:latin typeface="Times New Roman" panose="02020603050405020304" pitchFamily="18" charset="0"/>
                <a:cs typeface="Times New Roman" pitchFamily="18" charset="0"/>
              </a:rPr>
              <a:t>/pEspH</a:t>
            </a:r>
            <a:r>
              <a:rPr lang="en-US" b="1" i="1" baseline="-25000" dirty="0">
                <a:latin typeface="Times New Roman" panose="02020603050405020304" pitchFamily="18" charset="0"/>
                <a:cs typeface="Times New Roman" pitchFamily="18" charset="0"/>
              </a:rPr>
              <a:t>E37A</a:t>
            </a:r>
            <a:endParaRPr lang="en-US" b="1" baseline="-25000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2DE04CB-CE69-278E-EAA8-B228CCAC2F9D}"/>
              </a:ext>
            </a:extLst>
          </p:cNvPr>
          <p:cNvSpPr txBox="1"/>
          <p:nvPr/>
        </p:nvSpPr>
        <p:spPr>
          <a:xfrm>
            <a:off x="4959142" y="4065882"/>
            <a:ext cx="19337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itchFamily="18" charset="0"/>
              </a:rPr>
              <a:t>∆</a:t>
            </a:r>
            <a:r>
              <a:rPr lang="en-US" b="1" i="1" dirty="0" err="1">
                <a:latin typeface="Times New Roman" panose="02020603050405020304" pitchFamily="18" charset="0"/>
                <a:cs typeface="Times New Roman" pitchFamily="18" charset="0"/>
              </a:rPr>
              <a:t>esp</a:t>
            </a:r>
            <a:r>
              <a:rPr lang="en-US" b="1" dirty="0" err="1">
                <a:latin typeface="Times New Roman" panose="02020603050405020304" pitchFamily="18" charset="0"/>
                <a:cs typeface="Times New Roman" pitchFamily="18" charset="0"/>
              </a:rPr>
              <a:t>H</a:t>
            </a:r>
            <a:r>
              <a:rPr lang="en-US" b="1" dirty="0">
                <a:latin typeface="Times New Roman" panose="02020603050405020304" pitchFamily="18" charset="0"/>
                <a:cs typeface="Times New Roman" pitchFamily="18" charset="0"/>
              </a:rPr>
              <a:t>/pEspH</a:t>
            </a:r>
            <a:r>
              <a:rPr lang="en-US" b="1" i="1" baseline="-25000" dirty="0">
                <a:latin typeface="Times New Roman" panose="02020603050405020304" pitchFamily="18" charset="0"/>
                <a:cs typeface="Times New Roman" pitchFamily="18" charset="0"/>
              </a:rPr>
              <a:t>K41A</a:t>
            </a:r>
            <a:endParaRPr lang="en-US" b="1" baseline="-25000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B6ECB28-CB64-411F-97D1-07D10129431D}"/>
              </a:ext>
            </a:extLst>
          </p:cNvPr>
          <p:cNvSpPr txBox="1"/>
          <p:nvPr/>
        </p:nvSpPr>
        <p:spPr>
          <a:xfrm>
            <a:off x="0" y="-2743"/>
            <a:ext cx="148149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8b</a:t>
            </a:r>
            <a:endParaRPr lang="en-IL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1FD790E-FEA6-4E96-A26B-2EF00FBF0062}"/>
              </a:ext>
            </a:extLst>
          </p:cNvPr>
          <p:cNvSpPr txBox="1"/>
          <p:nvPr/>
        </p:nvSpPr>
        <p:spPr>
          <a:xfrm>
            <a:off x="4876571" y="349982"/>
            <a:ext cx="289348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Times New Roman" panose="02020603050405020304" pitchFamily="18" charset="0"/>
                <a:cs typeface="Times New Roman" pitchFamily="18" charset="0"/>
              </a:rPr>
              <a:t>eGFP-Rab10</a:t>
            </a:r>
            <a:r>
              <a:rPr lang="en-US" sz="2400" b="1" i="1" baseline="-25000" dirty="0">
                <a:latin typeface="Times New Roman" panose="02020603050405020304" pitchFamily="18" charset="0"/>
                <a:cs typeface="Times New Roman" pitchFamily="18" charset="0"/>
              </a:rPr>
              <a:t>wt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BC0B835-42F0-9BD2-021C-5150D59339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8425" y="1223860"/>
            <a:ext cx="5760000" cy="2707200"/>
          </a:xfrm>
          <a:prstGeom prst="rect">
            <a:avLst/>
          </a:prstGeom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A45B3B37-B4E7-BBE0-974F-41CA35B2016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20708" y="1156736"/>
            <a:ext cx="5760000" cy="2681599"/>
          </a:xfrm>
          <a:prstGeom prst="rect">
            <a:avLst/>
          </a:prstGeom>
        </p:spPr>
      </p:pic>
      <p:pic>
        <p:nvPicPr>
          <p:cNvPr id="60" name="Picture 59">
            <a:extLst>
              <a:ext uri="{FF2B5EF4-FFF2-40B4-BE49-F238E27FC236}">
                <a16:creationId xmlns:a16="http://schemas.microsoft.com/office/drawing/2014/main" id="{7DFCE5DF-CEA6-F771-A2D8-FA78E93425D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12936" y="4449717"/>
            <a:ext cx="5760000" cy="26777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1464971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08" name="Straight Connector 907">
            <a:extLst>
              <a:ext uri="{FF2B5EF4-FFF2-40B4-BE49-F238E27FC236}">
                <a16:creationId xmlns:a16="http://schemas.microsoft.com/office/drawing/2014/main" id="{997DBE96-7D12-5EFB-FE74-6FB1CCBD11D8}"/>
              </a:ext>
            </a:extLst>
          </p:cNvPr>
          <p:cNvCxnSpPr>
            <a:cxnSpLocks/>
          </p:cNvCxnSpPr>
          <p:nvPr/>
        </p:nvCxnSpPr>
        <p:spPr>
          <a:xfrm>
            <a:off x="3182920" y="7096004"/>
            <a:ext cx="9974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6" name="Straight Connector 915">
            <a:extLst>
              <a:ext uri="{FF2B5EF4-FFF2-40B4-BE49-F238E27FC236}">
                <a16:creationId xmlns:a16="http://schemas.microsoft.com/office/drawing/2014/main" id="{AB4A7276-3A10-6009-A0F7-98320508EFCE}"/>
              </a:ext>
            </a:extLst>
          </p:cNvPr>
          <p:cNvCxnSpPr>
            <a:cxnSpLocks/>
          </p:cNvCxnSpPr>
          <p:nvPr/>
        </p:nvCxnSpPr>
        <p:spPr>
          <a:xfrm>
            <a:off x="9857228" y="5922906"/>
            <a:ext cx="9974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D90949D6-37B0-7D9A-25CC-102594C60700}"/>
              </a:ext>
            </a:extLst>
          </p:cNvPr>
          <p:cNvSpPr txBox="1"/>
          <p:nvPr/>
        </p:nvSpPr>
        <p:spPr>
          <a:xfrm>
            <a:off x="1476473" y="706226"/>
            <a:ext cx="22658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itchFamily="18" charset="0"/>
              </a:rPr>
              <a:t>∆</a:t>
            </a:r>
            <a:r>
              <a:rPr lang="en-US" b="1" i="1" dirty="0" err="1">
                <a:latin typeface="Times New Roman" panose="02020603050405020304" pitchFamily="18" charset="0"/>
                <a:cs typeface="Times New Roman" pitchFamily="18" charset="0"/>
              </a:rPr>
              <a:t>esp</a:t>
            </a:r>
            <a:r>
              <a:rPr lang="en-US" b="1" dirty="0" err="1">
                <a:latin typeface="Times New Roman" panose="02020603050405020304" pitchFamily="18" charset="0"/>
                <a:cs typeface="Times New Roman" pitchFamily="18" charset="0"/>
              </a:rPr>
              <a:t>H</a:t>
            </a:r>
            <a:r>
              <a:rPr lang="en-US" b="1" dirty="0">
                <a:latin typeface="Times New Roman" panose="02020603050405020304" pitchFamily="18" charset="0"/>
                <a:cs typeface="Times New Roman" pitchFamily="18" charset="0"/>
              </a:rPr>
              <a:t>/pEspH</a:t>
            </a:r>
            <a:r>
              <a:rPr lang="en-US" b="1" i="1" baseline="-25000" dirty="0">
                <a:latin typeface="Times New Roman" panose="02020603050405020304" pitchFamily="18" charset="0"/>
                <a:cs typeface="Times New Roman" pitchFamily="18" charset="0"/>
              </a:rPr>
              <a:t>K106R</a:t>
            </a:r>
            <a:endParaRPr lang="en-US" b="1" baseline="-25000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E80CFF3-CA9A-1B61-2707-773502D10CF9}"/>
              </a:ext>
            </a:extLst>
          </p:cNvPr>
          <p:cNvSpPr txBox="1"/>
          <p:nvPr/>
        </p:nvSpPr>
        <p:spPr>
          <a:xfrm>
            <a:off x="6994434" y="680989"/>
            <a:ext cx="35347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itchFamily="18" charset="0"/>
              </a:rPr>
              <a:t>∆</a:t>
            </a:r>
            <a:r>
              <a:rPr lang="en-US" b="1" i="1" dirty="0" err="1">
                <a:latin typeface="Times New Roman" panose="02020603050405020304" pitchFamily="18" charset="0"/>
                <a:cs typeface="Times New Roman" pitchFamily="18" charset="0"/>
              </a:rPr>
              <a:t>esp</a:t>
            </a:r>
            <a:r>
              <a:rPr lang="en-US" b="1" dirty="0" err="1">
                <a:latin typeface="Times New Roman" panose="02020603050405020304" pitchFamily="18" charset="0"/>
                <a:cs typeface="Times New Roman" pitchFamily="18" charset="0"/>
              </a:rPr>
              <a:t>H</a:t>
            </a:r>
            <a:r>
              <a:rPr lang="en-US" b="1" dirty="0">
                <a:latin typeface="Times New Roman" panose="02020603050405020304" pitchFamily="18" charset="0"/>
                <a:cs typeface="Times New Roman" pitchFamily="18" charset="0"/>
              </a:rPr>
              <a:t>/pEspH</a:t>
            </a:r>
            <a:r>
              <a:rPr lang="en-US" b="1" i="1" baseline="-25000" dirty="0">
                <a:latin typeface="Times New Roman" panose="02020603050405020304" pitchFamily="18" charset="0"/>
                <a:cs typeface="Times New Roman" pitchFamily="18" charset="0"/>
              </a:rPr>
              <a:t>E37A</a:t>
            </a:r>
            <a:endParaRPr lang="en-US" b="1" baseline="-25000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4880457-B58E-A10C-B7BE-E28F08A5C96D}"/>
              </a:ext>
            </a:extLst>
          </p:cNvPr>
          <p:cNvSpPr txBox="1"/>
          <p:nvPr/>
        </p:nvSpPr>
        <p:spPr>
          <a:xfrm>
            <a:off x="4167226" y="4013351"/>
            <a:ext cx="27234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itchFamily="18" charset="0"/>
              </a:rPr>
              <a:t>∆</a:t>
            </a:r>
            <a:r>
              <a:rPr lang="en-US" b="1" i="1" dirty="0" err="1">
                <a:latin typeface="Times New Roman" panose="02020603050405020304" pitchFamily="18" charset="0"/>
                <a:cs typeface="Times New Roman" pitchFamily="18" charset="0"/>
              </a:rPr>
              <a:t>esp</a:t>
            </a:r>
            <a:r>
              <a:rPr lang="en-US" b="1" dirty="0" err="1">
                <a:latin typeface="Times New Roman" panose="02020603050405020304" pitchFamily="18" charset="0"/>
                <a:cs typeface="Times New Roman" pitchFamily="18" charset="0"/>
              </a:rPr>
              <a:t>H</a:t>
            </a:r>
            <a:r>
              <a:rPr lang="en-US" b="1" dirty="0">
                <a:latin typeface="Times New Roman" panose="02020603050405020304" pitchFamily="18" charset="0"/>
                <a:cs typeface="Times New Roman" pitchFamily="18" charset="0"/>
              </a:rPr>
              <a:t>/pEspH</a:t>
            </a:r>
            <a:r>
              <a:rPr lang="en-US" b="1" i="1" baseline="-25000" dirty="0">
                <a:latin typeface="Times New Roman" panose="02020603050405020304" pitchFamily="18" charset="0"/>
                <a:cs typeface="Times New Roman" pitchFamily="18" charset="0"/>
              </a:rPr>
              <a:t>K41A</a:t>
            </a:r>
            <a:endParaRPr lang="en-US" b="1" baseline="-25000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3F00DCC-2EBE-4C9C-A1A9-7A4E4CEABB41}"/>
              </a:ext>
            </a:extLst>
          </p:cNvPr>
          <p:cNvSpPr txBox="1"/>
          <p:nvPr/>
        </p:nvSpPr>
        <p:spPr>
          <a:xfrm>
            <a:off x="0" y="0"/>
            <a:ext cx="140134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8c</a:t>
            </a:r>
            <a:endParaRPr lang="en-IL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AC02C61-922C-41A8-95BB-507B8BCD5669}"/>
              </a:ext>
            </a:extLst>
          </p:cNvPr>
          <p:cNvSpPr txBox="1"/>
          <p:nvPr/>
        </p:nvSpPr>
        <p:spPr>
          <a:xfrm>
            <a:off x="5059289" y="244561"/>
            <a:ext cx="21865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Times New Roman" panose="02020603050405020304" pitchFamily="18" charset="0"/>
                <a:cs typeface="Times New Roman" pitchFamily="18" charset="0"/>
              </a:rPr>
              <a:t>eGFP-Rab3a</a:t>
            </a:r>
            <a:r>
              <a:rPr lang="en-US" sz="2400" b="1" i="1" baseline="-25000" dirty="0">
                <a:latin typeface="Times New Roman" panose="02020603050405020304" pitchFamily="18" charset="0"/>
                <a:cs typeface="Times New Roman" pitchFamily="18" charset="0"/>
              </a:rPr>
              <a:t>wt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5493AD3-41F6-5101-925F-3B5C75AEFA4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11240"/>
          <a:stretch/>
        </p:blipFill>
        <p:spPr>
          <a:xfrm>
            <a:off x="688425" y="1050321"/>
            <a:ext cx="5760000" cy="277743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EDCE060-8DCC-F6F1-36DA-7CB42BC5F33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16594" y="1003172"/>
            <a:ext cx="5760000" cy="271323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C6D990B-D4D1-F370-D8E8-0001F01925C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45484" y="4382683"/>
            <a:ext cx="5760000" cy="27321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252051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08" name="Straight Connector 907">
            <a:extLst>
              <a:ext uri="{FF2B5EF4-FFF2-40B4-BE49-F238E27FC236}">
                <a16:creationId xmlns:a16="http://schemas.microsoft.com/office/drawing/2014/main" id="{997DBE96-7D12-5EFB-FE74-6FB1CCBD11D8}"/>
              </a:ext>
            </a:extLst>
          </p:cNvPr>
          <p:cNvCxnSpPr>
            <a:cxnSpLocks/>
          </p:cNvCxnSpPr>
          <p:nvPr/>
        </p:nvCxnSpPr>
        <p:spPr>
          <a:xfrm>
            <a:off x="3182920" y="7096004"/>
            <a:ext cx="9974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4B92F7A3-006E-4AB3-9AF2-055A3C3F011A}"/>
              </a:ext>
            </a:extLst>
          </p:cNvPr>
          <p:cNvSpPr txBox="1"/>
          <p:nvPr/>
        </p:nvSpPr>
        <p:spPr>
          <a:xfrm>
            <a:off x="0" y="0"/>
            <a:ext cx="144302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8d</a:t>
            </a:r>
            <a:endParaRPr lang="en-IL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0CEA2101-53CD-DEFB-012C-91A6F039B5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3498" y="369332"/>
            <a:ext cx="5769463" cy="601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2688042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TextBox 65">
            <a:extLst>
              <a:ext uri="{FF2B5EF4-FFF2-40B4-BE49-F238E27FC236}">
                <a16:creationId xmlns:a16="http://schemas.microsoft.com/office/drawing/2014/main" id="{574866E4-A25D-4D2F-A99B-E9C3DE268ACA}"/>
              </a:ext>
            </a:extLst>
          </p:cNvPr>
          <p:cNvSpPr txBox="1"/>
          <p:nvPr/>
        </p:nvSpPr>
        <p:spPr>
          <a:xfrm>
            <a:off x="16128" y="198"/>
            <a:ext cx="124264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9</a:t>
            </a:r>
            <a:endParaRPr lang="en-IL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DBD89C3-0EE4-EC0E-F713-72771AA91465}"/>
              </a:ext>
            </a:extLst>
          </p:cNvPr>
          <p:cNvSpPr txBox="1"/>
          <p:nvPr/>
        </p:nvSpPr>
        <p:spPr>
          <a:xfrm>
            <a:off x="6515861" y="1855560"/>
            <a:ext cx="2191626" cy="5155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7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  <a:r>
              <a:rPr lang="en-US" sz="2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gnaling</a:t>
            </a:r>
            <a:endParaRPr lang="en-IL" sz="27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337BA90-B154-A89F-CF7F-693924E97164}"/>
              </a:ext>
            </a:extLst>
          </p:cNvPr>
          <p:cNvSpPr txBox="1"/>
          <p:nvPr/>
        </p:nvSpPr>
        <p:spPr>
          <a:xfrm>
            <a:off x="9508882" y="1855559"/>
            <a:ext cx="3107004" cy="5155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TORC1 signaling</a:t>
            </a:r>
            <a:endParaRPr lang="en-IL" sz="27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7402C30F-6B70-E928-0972-DE7A8D7CF43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23440" y="2371085"/>
            <a:ext cx="3097207" cy="37800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7EAA0F27-A6CB-A80C-5E95-B6A4272B001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375569" y="2371085"/>
            <a:ext cx="3373629" cy="37800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5817116C-2C6C-6471-EAD3-CF9E1E3C5B8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-17670" y="575597"/>
            <a:ext cx="6431837" cy="623065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FF9EE99-49A7-CE51-666E-12EEC434F7D8}"/>
              </a:ext>
            </a:extLst>
          </p:cNvPr>
          <p:cNvSpPr txBox="1"/>
          <p:nvPr/>
        </p:nvSpPr>
        <p:spPr>
          <a:xfrm>
            <a:off x="1542381" y="360360"/>
            <a:ext cx="2530481" cy="40011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eLa cells</a:t>
            </a:r>
            <a:endParaRPr lang="he-IL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85E3B496-3F2B-8F55-C63A-D41194A3D4B8}"/>
              </a:ext>
            </a:extLst>
          </p:cNvPr>
          <p:cNvCxnSpPr/>
          <p:nvPr/>
        </p:nvCxnSpPr>
        <p:spPr>
          <a:xfrm>
            <a:off x="940285" y="776375"/>
            <a:ext cx="3672000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7027698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4B92F7A3-006E-4AB3-9AF2-055A3C3F011A}"/>
              </a:ext>
            </a:extLst>
          </p:cNvPr>
          <p:cNvSpPr txBox="1"/>
          <p:nvPr/>
        </p:nvSpPr>
        <p:spPr>
          <a:xfrm>
            <a:off x="0" y="0"/>
            <a:ext cx="142218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0</a:t>
            </a:r>
            <a:endParaRPr lang="en-IL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41EDB9C-7C95-5565-8FD7-CF02B211994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50003" y="360786"/>
            <a:ext cx="2700000" cy="3261188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8E157FDC-4FFF-4F0E-F278-844D4E7E5A82}"/>
              </a:ext>
            </a:extLst>
          </p:cNvPr>
          <p:cNvSpPr txBox="1"/>
          <p:nvPr/>
        </p:nvSpPr>
        <p:spPr>
          <a:xfrm>
            <a:off x="7242947" y="110281"/>
            <a:ext cx="1499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gnaling</a:t>
            </a:r>
            <a:endParaRPr lang="en-I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498449D-9638-7BF9-7DD3-9B73116F7DC6}"/>
              </a:ext>
            </a:extLst>
          </p:cNvPr>
          <p:cNvSpPr txBox="1"/>
          <p:nvPr/>
        </p:nvSpPr>
        <p:spPr>
          <a:xfrm>
            <a:off x="7016025" y="3555545"/>
            <a:ext cx="20976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TORC1 signaling</a:t>
            </a:r>
            <a:endParaRPr lang="en-I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880F2FF-DEA3-490B-825A-DD9EA45E22A2}"/>
              </a:ext>
            </a:extLst>
          </p:cNvPr>
          <p:cNvSpPr txBox="1"/>
          <p:nvPr/>
        </p:nvSpPr>
        <p:spPr>
          <a:xfrm>
            <a:off x="2301501" y="179208"/>
            <a:ext cx="2530481" cy="40011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co-2</a:t>
            </a:r>
            <a:r>
              <a:rPr lang="en-US" sz="2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Be 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endParaRPr lang="he-IL" sz="2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2C5B6E43-99F3-B931-E9BB-F8D4D19C04E4}"/>
              </a:ext>
            </a:extLst>
          </p:cNvPr>
          <p:cNvCxnSpPr/>
          <p:nvPr/>
        </p:nvCxnSpPr>
        <p:spPr>
          <a:xfrm>
            <a:off x="1871932" y="595223"/>
            <a:ext cx="333842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3" name="Picture 2">
            <a:extLst>
              <a:ext uri="{FF2B5EF4-FFF2-40B4-BE49-F238E27FC236}">
                <a16:creationId xmlns:a16="http://schemas.microsoft.com/office/drawing/2014/main" id="{340D26C5-4C92-7030-30CC-ACBCD0CF2B5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51812" y="488158"/>
            <a:ext cx="5596613" cy="5230821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0C04C06C-DF08-9916-D192-C4BF5B2C480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14870" y="3872145"/>
            <a:ext cx="2700000" cy="30438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8021208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-up of several colorful spirals&#10;&#10;Description automatically generated">
            <a:extLst>
              <a:ext uri="{FF2B5EF4-FFF2-40B4-BE49-F238E27FC236}">
                <a16:creationId xmlns:a16="http://schemas.microsoft.com/office/drawing/2014/main" id="{84D25359-1FE2-49AB-906E-700B5F09BE7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1700" y="1198245"/>
            <a:ext cx="8160710" cy="410718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04659C6-F539-3024-51CA-71F65E612A81}"/>
              </a:ext>
            </a:extLst>
          </p:cNvPr>
          <p:cNvSpPr txBox="1"/>
          <p:nvPr/>
        </p:nvSpPr>
        <p:spPr>
          <a:xfrm>
            <a:off x="7372135" y="3729643"/>
            <a:ext cx="915528" cy="403508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02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44</a:t>
            </a:r>
            <a:endParaRPr lang="he-IL" sz="202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B9839C1-A681-D8D7-EFBA-FED50F5A0778}"/>
              </a:ext>
            </a:extLst>
          </p:cNvPr>
          <p:cNvSpPr txBox="1"/>
          <p:nvPr/>
        </p:nvSpPr>
        <p:spPr>
          <a:xfrm rot="19529978">
            <a:off x="7425720" y="2397571"/>
            <a:ext cx="763009" cy="403508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02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46</a:t>
            </a:r>
            <a:endParaRPr lang="he-IL" sz="202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B7ED7FD-1D29-2D08-1307-1C8D89CE1548}"/>
              </a:ext>
            </a:extLst>
          </p:cNvPr>
          <p:cNvSpPr txBox="1"/>
          <p:nvPr/>
        </p:nvSpPr>
        <p:spPr>
          <a:xfrm rot="1258625">
            <a:off x="5692447" y="2152687"/>
            <a:ext cx="829973" cy="403508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02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37</a:t>
            </a:r>
            <a:endParaRPr lang="he-IL" sz="202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E9B534F-BAEB-A6C1-469D-80D519A1539F}"/>
              </a:ext>
            </a:extLst>
          </p:cNvPr>
          <p:cNvSpPr txBox="1"/>
          <p:nvPr/>
        </p:nvSpPr>
        <p:spPr>
          <a:xfrm>
            <a:off x="5663859" y="3347273"/>
            <a:ext cx="798179" cy="403508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02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41</a:t>
            </a:r>
            <a:endParaRPr lang="he-IL" sz="202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4322138-72AA-E5C4-5F53-7836070F798D}"/>
              </a:ext>
            </a:extLst>
          </p:cNvPr>
          <p:cNvSpPr txBox="1"/>
          <p:nvPr/>
        </p:nvSpPr>
        <p:spPr>
          <a:xfrm rot="20519965">
            <a:off x="4045025" y="3233818"/>
            <a:ext cx="798179" cy="403508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022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68</a:t>
            </a:r>
            <a:endParaRPr lang="he-IL" sz="2022" b="1" dirty="0">
              <a:solidFill>
                <a:schemeClr val="tx1">
                  <a:lumMod val="95000"/>
                  <a:lumOff val="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51CDE7B-CD74-4534-381F-F6BB14445150}"/>
              </a:ext>
            </a:extLst>
          </p:cNvPr>
          <p:cNvSpPr txBox="1"/>
          <p:nvPr/>
        </p:nvSpPr>
        <p:spPr>
          <a:xfrm>
            <a:off x="0" y="0"/>
            <a:ext cx="140237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1</a:t>
            </a:r>
            <a:endParaRPr lang="en-IL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422D2E5-9CD9-3E4C-34BC-8C96C0CD4151}"/>
              </a:ext>
            </a:extLst>
          </p:cNvPr>
          <p:cNvSpPr txBox="1"/>
          <p:nvPr/>
        </p:nvSpPr>
        <p:spPr>
          <a:xfrm>
            <a:off x="2171700" y="661303"/>
            <a:ext cx="2407694" cy="53694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889" dirty="0">
                <a:solidFill>
                  <a:srgbClr val="FF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spH</a:t>
            </a:r>
            <a:r>
              <a:rPr lang="en-US" sz="2889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2889" dirty="0">
                <a:solidFill>
                  <a:srgbClr val="777777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b8a</a:t>
            </a:r>
            <a:endParaRPr lang="he-IL" sz="2889" dirty="0">
              <a:solidFill>
                <a:srgbClr val="777777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501228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Box 35">
            <a:extLst>
              <a:ext uri="{FF2B5EF4-FFF2-40B4-BE49-F238E27FC236}">
                <a16:creationId xmlns:a16="http://schemas.microsoft.com/office/drawing/2014/main" id="{2D6297AC-A801-42AA-9760-BEB0ECF32D5C}"/>
              </a:ext>
            </a:extLst>
          </p:cNvPr>
          <p:cNvSpPr txBox="1"/>
          <p:nvPr/>
        </p:nvSpPr>
        <p:spPr>
          <a:xfrm>
            <a:off x="16127" y="198"/>
            <a:ext cx="142218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2</a:t>
            </a:r>
            <a:endParaRPr lang="en-IL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5049B9C4-4B9D-794C-339E-5B09B53B27C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18414" y="1270132"/>
            <a:ext cx="6297714" cy="38347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39943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TextBox 101">
            <a:extLst>
              <a:ext uri="{FF2B5EF4-FFF2-40B4-BE49-F238E27FC236}">
                <a16:creationId xmlns:a16="http://schemas.microsoft.com/office/drawing/2014/main" id="{967734CA-C002-4B68-9E4C-394ADA4DFFE2}"/>
              </a:ext>
            </a:extLst>
          </p:cNvPr>
          <p:cNvSpPr txBox="1"/>
          <p:nvPr/>
        </p:nvSpPr>
        <p:spPr>
          <a:xfrm>
            <a:off x="16128" y="198"/>
            <a:ext cx="124264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</a:t>
            </a:r>
            <a:endParaRPr lang="en-IL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21260E8-ED6E-09F9-4515-70F18BEAAE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6742" y="180094"/>
            <a:ext cx="10800000" cy="68946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711178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3B8C47C8-A5B0-05A1-6BB8-B2B12264C343}"/>
              </a:ext>
            </a:extLst>
          </p:cNvPr>
          <p:cNvSpPr txBox="1"/>
          <p:nvPr/>
        </p:nvSpPr>
        <p:spPr>
          <a:xfrm>
            <a:off x="0" y="0"/>
            <a:ext cx="124264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</a:t>
            </a:r>
            <a:endParaRPr lang="en-IL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8780CD20-F16C-8752-8803-49677F68C0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59287" y="1312502"/>
            <a:ext cx="5778275" cy="334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973560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2890E4D6-BD7C-39E3-D268-B608B533E553}"/>
              </a:ext>
            </a:extLst>
          </p:cNvPr>
          <p:cNvSpPr txBox="1"/>
          <p:nvPr/>
        </p:nvSpPr>
        <p:spPr>
          <a:xfrm>
            <a:off x="0" y="0"/>
            <a:ext cx="124264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</a:t>
            </a:r>
            <a:endParaRPr lang="en-IL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A1246F0-21CB-3DB7-8718-95C60BBAD31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28844" y="680261"/>
            <a:ext cx="3981033" cy="50662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375433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C97A4AE-9495-4DFB-A428-AE48D9E0AF7B}"/>
              </a:ext>
            </a:extLst>
          </p:cNvPr>
          <p:cNvSpPr txBox="1"/>
          <p:nvPr/>
        </p:nvSpPr>
        <p:spPr>
          <a:xfrm>
            <a:off x="0" y="22066"/>
            <a:ext cx="201208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5 </a:t>
            </a:r>
            <a:r>
              <a:rPr lang="en-US" sz="2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&amp;b</a:t>
            </a:r>
            <a:endParaRPr lang="en-IL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D03B4A0-D34B-4B91-AE17-58F0A7C00272}"/>
              </a:ext>
            </a:extLst>
          </p:cNvPr>
          <p:cNvSpPr txBox="1"/>
          <p:nvPr/>
        </p:nvSpPr>
        <p:spPr>
          <a:xfrm rot="16200000">
            <a:off x="3428451" y="1061747"/>
            <a:ext cx="16129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GFP-Rab3a</a:t>
            </a:r>
            <a:r>
              <a:rPr lang="en-US" b="1" i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lang="en-IL" b="1" i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913C498-0770-45D8-B49D-906E08F66875}"/>
              </a:ext>
            </a:extLst>
          </p:cNvPr>
          <p:cNvSpPr txBox="1"/>
          <p:nvPr/>
        </p:nvSpPr>
        <p:spPr>
          <a:xfrm rot="16200000">
            <a:off x="3321851" y="3522139"/>
            <a:ext cx="18261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GFP-Rab3a</a:t>
            </a:r>
            <a:r>
              <a:rPr lang="en-US" b="1" i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36N</a:t>
            </a:r>
            <a:endParaRPr lang="en-IL" b="1" i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A3177C5-8B24-4829-A69F-538D23136E21}"/>
              </a:ext>
            </a:extLst>
          </p:cNvPr>
          <p:cNvSpPr txBox="1"/>
          <p:nvPr/>
        </p:nvSpPr>
        <p:spPr>
          <a:xfrm rot="16200000">
            <a:off x="3313225" y="5771968"/>
            <a:ext cx="18261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GFP-Rab3a</a:t>
            </a:r>
            <a:r>
              <a:rPr lang="en-US" b="1" i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81L</a:t>
            </a:r>
            <a:endParaRPr lang="en-IL" b="1" i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E5E59C51-60F3-4B5E-80EC-F69EC19EDE54}"/>
              </a:ext>
            </a:extLst>
          </p:cNvPr>
          <p:cNvCxnSpPr/>
          <p:nvPr/>
        </p:nvCxnSpPr>
        <p:spPr>
          <a:xfrm>
            <a:off x="4423464" y="5095320"/>
            <a:ext cx="0" cy="1944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EC5638F8-FB74-47EF-BE6B-524D4B1A06EC}"/>
              </a:ext>
            </a:extLst>
          </p:cNvPr>
          <p:cNvCxnSpPr/>
          <p:nvPr/>
        </p:nvCxnSpPr>
        <p:spPr>
          <a:xfrm>
            <a:off x="4432090" y="2771567"/>
            <a:ext cx="0" cy="1908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A4226FD9-77B9-47D0-B700-93ED1BAABC8C}"/>
              </a:ext>
            </a:extLst>
          </p:cNvPr>
          <p:cNvCxnSpPr/>
          <p:nvPr/>
        </p:nvCxnSpPr>
        <p:spPr>
          <a:xfrm>
            <a:off x="4440716" y="320154"/>
            <a:ext cx="0" cy="1908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Picture 1">
            <a:extLst>
              <a:ext uri="{FF2B5EF4-FFF2-40B4-BE49-F238E27FC236}">
                <a16:creationId xmlns:a16="http://schemas.microsoft.com/office/drawing/2014/main" id="{492D4E6F-7831-C74E-90BC-E40F5E8C89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88834" y="264928"/>
            <a:ext cx="6480000" cy="1987763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5DB7D05D-8790-2E2E-0D38-AFD0F878D42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88835" y="2679409"/>
            <a:ext cx="6480000" cy="202138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799289D9-CD57-4EB1-6BCD-6F91BBC780D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88836" y="5031151"/>
            <a:ext cx="6480000" cy="198938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D4296D5-BA0D-E141-4EB1-4EF231FBDA9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-105364" y="2252691"/>
            <a:ext cx="4300352" cy="32400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32AD8CF-95BC-AA65-853E-D26C3284A19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379013" y="1594380"/>
            <a:ext cx="2517837" cy="3060000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AD9EE914-7DD8-423F-8301-5E12B2985061}"/>
              </a:ext>
            </a:extLst>
          </p:cNvPr>
          <p:cNvSpPr txBox="1"/>
          <p:nvPr/>
        </p:nvSpPr>
        <p:spPr>
          <a:xfrm>
            <a:off x="107888" y="1725574"/>
            <a:ext cx="448703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he-IL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8AECA64-16E0-4E36-902C-C7F8FC64E0D6}"/>
              </a:ext>
            </a:extLst>
          </p:cNvPr>
          <p:cNvSpPr txBox="1"/>
          <p:nvPr/>
        </p:nvSpPr>
        <p:spPr>
          <a:xfrm>
            <a:off x="3644332" y="-69161"/>
            <a:ext cx="538880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he-IL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95635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C97A4AE-9495-4DFB-A428-AE48D9E0AF7B}"/>
              </a:ext>
            </a:extLst>
          </p:cNvPr>
          <p:cNvSpPr txBox="1"/>
          <p:nvPr/>
        </p:nvSpPr>
        <p:spPr>
          <a:xfrm>
            <a:off x="0" y="0"/>
            <a:ext cx="205056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5 </a:t>
            </a:r>
            <a:r>
              <a:rPr lang="en-US" sz="2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&amp;d</a:t>
            </a:r>
            <a:endParaRPr lang="en-IL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F0A2520-1D59-4630-B9CD-BF11EC34B8B2}"/>
              </a:ext>
            </a:extLst>
          </p:cNvPr>
          <p:cNvSpPr txBox="1"/>
          <p:nvPr/>
        </p:nvSpPr>
        <p:spPr>
          <a:xfrm rot="16200000">
            <a:off x="3557669" y="1045393"/>
            <a:ext cx="16129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GFP-Rab10</a:t>
            </a:r>
            <a:r>
              <a:rPr lang="en-US" b="1" i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lang="en-IL" b="1" i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2DE7306-183F-424D-88C8-3511194ADE69}"/>
              </a:ext>
            </a:extLst>
          </p:cNvPr>
          <p:cNvSpPr txBox="1"/>
          <p:nvPr/>
        </p:nvSpPr>
        <p:spPr>
          <a:xfrm rot="16200000">
            <a:off x="3442443" y="3358504"/>
            <a:ext cx="18261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GFP-Rab10</a:t>
            </a:r>
            <a:r>
              <a:rPr lang="en-US" b="1" i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23N</a:t>
            </a:r>
            <a:endParaRPr lang="en-IL" b="1" i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6769116-F45F-4B2C-B713-2AA0342C68F0}"/>
              </a:ext>
            </a:extLst>
          </p:cNvPr>
          <p:cNvSpPr txBox="1"/>
          <p:nvPr/>
        </p:nvSpPr>
        <p:spPr>
          <a:xfrm rot="16200000">
            <a:off x="3442446" y="5862178"/>
            <a:ext cx="18261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GFP-Rab10</a:t>
            </a:r>
            <a:r>
              <a:rPr lang="en-US" b="1" i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68L</a:t>
            </a:r>
            <a:endParaRPr lang="en-IL" b="1" i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847A3679-90F4-4650-8AFA-D950ECF29670}"/>
              </a:ext>
            </a:extLst>
          </p:cNvPr>
          <p:cNvCxnSpPr/>
          <p:nvPr/>
        </p:nvCxnSpPr>
        <p:spPr>
          <a:xfrm>
            <a:off x="4552046" y="5151731"/>
            <a:ext cx="0" cy="1728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707323BD-CA8F-4317-9791-34C38BE5865A}"/>
              </a:ext>
            </a:extLst>
          </p:cNvPr>
          <p:cNvCxnSpPr/>
          <p:nvPr/>
        </p:nvCxnSpPr>
        <p:spPr>
          <a:xfrm>
            <a:off x="4560669" y="2696115"/>
            <a:ext cx="0" cy="1692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50123897-2D44-468F-8BA3-7E98D14A529B}"/>
              </a:ext>
            </a:extLst>
          </p:cNvPr>
          <p:cNvCxnSpPr/>
          <p:nvPr/>
        </p:nvCxnSpPr>
        <p:spPr>
          <a:xfrm>
            <a:off x="4569295" y="343573"/>
            <a:ext cx="0" cy="1764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4" name="Picture 163">
            <a:extLst>
              <a:ext uri="{FF2B5EF4-FFF2-40B4-BE49-F238E27FC236}">
                <a16:creationId xmlns:a16="http://schemas.microsoft.com/office/drawing/2014/main" id="{A637C098-3043-05FC-E99A-1F76B821414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943" b="66352"/>
          <a:stretch/>
        </p:blipFill>
        <p:spPr>
          <a:xfrm>
            <a:off x="4598020" y="282102"/>
            <a:ext cx="6120000" cy="1953366"/>
          </a:xfrm>
          <a:prstGeom prst="rect">
            <a:avLst/>
          </a:prstGeom>
        </p:spPr>
      </p:pic>
      <p:pic>
        <p:nvPicPr>
          <p:cNvPr id="167" name="Picture 166">
            <a:extLst>
              <a:ext uri="{FF2B5EF4-FFF2-40B4-BE49-F238E27FC236}">
                <a16:creationId xmlns:a16="http://schemas.microsoft.com/office/drawing/2014/main" id="{F03A58D2-8EFC-F41C-7D79-D5CD7704ACE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462"/>
          <a:stretch/>
        </p:blipFill>
        <p:spPr>
          <a:xfrm>
            <a:off x="4606646" y="5065216"/>
            <a:ext cx="6120000" cy="1904563"/>
          </a:xfrm>
          <a:prstGeom prst="rect">
            <a:avLst/>
          </a:prstGeom>
        </p:spPr>
      </p:pic>
      <p:pic>
        <p:nvPicPr>
          <p:cNvPr id="168" name="Picture 167">
            <a:extLst>
              <a:ext uri="{FF2B5EF4-FFF2-40B4-BE49-F238E27FC236}">
                <a16:creationId xmlns:a16="http://schemas.microsoft.com/office/drawing/2014/main" id="{19CC20FD-652E-D4AD-FF47-377F4E55ABD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2941"/>
          <a:stretch/>
        </p:blipFill>
        <p:spPr>
          <a:xfrm>
            <a:off x="4606643" y="2611524"/>
            <a:ext cx="6120000" cy="188863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B5331888-B42E-8CB2-3899-61D71A131CD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348623" y="1662250"/>
            <a:ext cx="2524368" cy="324000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A7E75A4B-24AA-4BAD-80C2-89227CA18CB7}"/>
              </a:ext>
            </a:extLst>
          </p:cNvPr>
          <p:cNvSpPr txBox="1"/>
          <p:nvPr/>
        </p:nvSpPr>
        <p:spPr>
          <a:xfrm>
            <a:off x="127767" y="1662250"/>
            <a:ext cx="538880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he-IL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4DEF9E8-F511-41D2-B283-B3BC23CF52DE}"/>
              </a:ext>
            </a:extLst>
          </p:cNvPr>
          <p:cNvSpPr txBox="1"/>
          <p:nvPr/>
        </p:nvSpPr>
        <p:spPr>
          <a:xfrm>
            <a:off x="3626232" y="-15446"/>
            <a:ext cx="538880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he-IL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2C085CD-064D-AD05-482D-00632C58DA5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0" y="1898050"/>
            <a:ext cx="4320000" cy="32357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4251103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B54EF15F-56AC-83B0-35BB-8B53EA52A6F5}"/>
              </a:ext>
            </a:extLst>
          </p:cNvPr>
          <p:cNvSpPr txBox="1"/>
          <p:nvPr/>
        </p:nvSpPr>
        <p:spPr>
          <a:xfrm>
            <a:off x="0" y="0"/>
            <a:ext cx="127568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6</a:t>
            </a:r>
            <a:endParaRPr lang="he-IL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41BF9F9-45C7-80B4-C348-1A9E23A0ECB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75689" y="3785620"/>
            <a:ext cx="10800000" cy="2715405"/>
          </a:xfrm>
          <a:prstGeom prst="rect">
            <a:avLst/>
          </a:prstGeom>
        </p:spPr>
      </p:pic>
      <p:pic>
        <p:nvPicPr>
          <p:cNvPr id="68" name="Picture 67">
            <a:extLst>
              <a:ext uri="{FF2B5EF4-FFF2-40B4-BE49-F238E27FC236}">
                <a16:creationId xmlns:a16="http://schemas.microsoft.com/office/drawing/2014/main" id="{0D6A323C-EA78-E58F-EFEB-F299B467CA6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75689" y="537151"/>
            <a:ext cx="10800000" cy="293210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2C9B348-5127-448B-9932-9AE870C4F9AF}"/>
              </a:ext>
            </a:extLst>
          </p:cNvPr>
          <p:cNvSpPr txBox="1"/>
          <p:nvPr/>
        </p:nvSpPr>
        <p:spPr>
          <a:xfrm>
            <a:off x="1549155" y="177949"/>
            <a:ext cx="538880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he-IL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4C9C5A1-619A-45A3-8E3F-214391BCB2F5}"/>
              </a:ext>
            </a:extLst>
          </p:cNvPr>
          <p:cNvSpPr txBox="1"/>
          <p:nvPr/>
        </p:nvSpPr>
        <p:spPr>
          <a:xfrm>
            <a:off x="4841832" y="177948"/>
            <a:ext cx="538880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he-IL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334D51C-A41A-47E7-8B6B-412D4AAD8731}"/>
              </a:ext>
            </a:extLst>
          </p:cNvPr>
          <p:cNvSpPr txBox="1"/>
          <p:nvPr/>
        </p:nvSpPr>
        <p:spPr>
          <a:xfrm>
            <a:off x="7595629" y="177947"/>
            <a:ext cx="538880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he-IL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9523A9B-6CEF-4B26-9DEA-C233936CB1F5}"/>
              </a:ext>
            </a:extLst>
          </p:cNvPr>
          <p:cNvSpPr txBox="1"/>
          <p:nvPr/>
        </p:nvSpPr>
        <p:spPr>
          <a:xfrm>
            <a:off x="1549155" y="3627437"/>
            <a:ext cx="538880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he-IL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A6CBCDC-E02C-4333-8CA3-7DD4EF109098}"/>
              </a:ext>
            </a:extLst>
          </p:cNvPr>
          <p:cNvSpPr txBox="1"/>
          <p:nvPr/>
        </p:nvSpPr>
        <p:spPr>
          <a:xfrm>
            <a:off x="5111272" y="3627436"/>
            <a:ext cx="538880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he-IL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E7F3885-4719-4352-A8CE-10AD77CF19C0}"/>
              </a:ext>
            </a:extLst>
          </p:cNvPr>
          <p:cNvSpPr txBox="1"/>
          <p:nvPr/>
        </p:nvSpPr>
        <p:spPr>
          <a:xfrm>
            <a:off x="7865069" y="3627435"/>
            <a:ext cx="538880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he-IL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957683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TextBox 48">
            <a:extLst>
              <a:ext uri="{FF2B5EF4-FFF2-40B4-BE49-F238E27FC236}">
                <a16:creationId xmlns:a16="http://schemas.microsoft.com/office/drawing/2014/main" id="{1F35DFDA-D9C6-4AE0-9E98-83327B7FF10D}"/>
              </a:ext>
            </a:extLst>
          </p:cNvPr>
          <p:cNvSpPr txBox="1"/>
          <p:nvPr/>
        </p:nvSpPr>
        <p:spPr>
          <a:xfrm>
            <a:off x="0" y="0"/>
            <a:ext cx="127220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7</a:t>
            </a:r>
            <a:endParaRPr lang="he-IL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0911995-DBE8-6876-6772-2BC579EDE6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70509" y="1234070"/>
            <a:ext cx="4483636" cy="417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313434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1BF5C4EA-754A-9767-3814-A42B717B234A}"/>
              </a:ext>
            </a:extLst>
          </p:cNvPr>
          <p:cNvSpPr txBox="1"/>
          <p:nvPr/>
        </p:nvSpPr>
        <p:spPr>
          <a:xfrm>
            <a:off x="1816087" y="914378"/>
            <a:ext cx="19888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itchFamily="18" charset="0"/>
              </a:rPr>
              <a:t>∆</a:t>
            </a:r>
            <a:r>
              <a:rPr lang="en-US" b="1" i="1" dirty="0" err="1">
                <a:latin typeface="Times New Roman" panose="02020603050405020304" pitchFamily="18" charset="0"/>
                <a:cs typeface="Times New Roman" pitchFamily="18" charset="0"/>
              </a:rPr>
              <a:t>esp</a:t>
            </a:r>
            <a:r>
              <a:rPr lang="en-US" b="1" dirty="0" err="1">
                <a:latin typeface="Times New Roman" panose="02020603050405020304" pitchFamily="18" charset="0"/>
                <a:cs typeface="Times New Roman" pitchFamily="18" charset="0"/>
              </a:rPr>
              <a:t>H</a:t>
            </a:r>
            <a:r>
              <a:rPr lang="en-US" b="1" dirty="0">
                <a:latin typeface="Times New Roman" panose="02020603050405020304" pitchFamily="18" charset="0"/>
                <a:cs typeface="Times New Roman" pitchFamily="18" charset="0"/>
              </a:rPr>
              <a:t>/pEspH</a:t>
            </a:r>
            <a:r>
              <a:rPr lang="en-US" b="1" i="1" baseline="-25000" dirty="0">
                <a:latin typeface="Times New Roman" panose="02020603050405020304" pitchFamily="18" charset="0"/>
                <a:cs typeface="Times New Roman" pitchFamily="18" charset="0"/>
              </a:rPr>
              <a:t>K106R</a:t>
            </a:r>
            <a:endParaRPr lang="en-US" b="1" baseline="-25000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E07DC75-B456-F8ED-981A-FFBA153DB7BB}"/>
              </a:ext>
            </a:extLst>
          </p:cNvPr>
          <p:cNvSpPr txBox="1"/>
          <p:nvPr/>
        </p:nvSpPr>
        <p:spPr>
          <a:xfrm>
            <a:off x="7963261" y="901233"/>
            <a:ext cx="1992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itchFamily="18" charset="0"/>
              </a:rPr>
              <a:t>∆</a:t>
            </a:r>
            <a:r>
              <a:rPr lang="en-US" b="1" i="1" dirty="0" err="1">
                <a:latin typeface="Times New Roman" panose="02020603050405020304" pitchFamily="18" charset="0"/>
                <a:cs typeface="Times New Roman" pitchFamily="18" charset="0"/>
              </a:rPr>
              <a:t>esp</a:t>
            </a:r>
            <a:r>
              <a:rPr lang="en-US" b="1" dirty="0" err="1">
                <a:latin typeface="Times New Roman" panose="02020603050405020304" pitchFamily="18" charset="0"/>
                <a:cs typeface="Times New Roman" pitchFamily="18" charset="0"/>
              </a:rPr>
              <a:t>H</a:t>
            </a:r>
            <a:r>
              <a:rPr lang="en-US" b="1" dirty="0">
                <a:latin typeface="Times New Roman" panose="02020603050405020304" pitchFamily="18" charset="0"/>
                <a:cs typeface="Times New Roman" pitchFamily="18" charset="0"/>
              </a:rPr>
              <a:t>/pEspH</a:t>
            </a:r>
            <a:r>
              <a:rPr lang="en-US" b="1" i="1" baseline="-25000" dirty="0">
                <a:latin typeface="Times New Roman" panose="02020603050405020304" pitchFamily="18" charset="0"/>
                <a:cs typeface="Times New Roman" pitchFamily="18" charset="0"/>
              </a:rPr>
              <a:t>E37A</a:t>
            </a:r>
            <a:endParaRPr lang="en-US" b="1" baseline="-25000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3E256AB-C8B5-C597-69F7-288FF3BFD36A}"/>
              </a:ext>
            </a:extLst>
          </p:cNvPr>
          <p:cNvSpPr txBox="1"/>
          <p:nvPr/>
        </p:nvSpPr>
        <p:spPr>
          <a:xfrm>
            <a:off x="5194842" y="4100571"/>
            <a:ext cx="19198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itchFamily="18" charset="0"/>
              </a:rPr>
              <a:t>∆</a:t>
            </a:r>
            <a:r>
              <a:rPr lang="en-US" b="1" i="1" dirty="0" err="1">
                <a:latin typeface="Times New Roman" panose="02020603050405020304" pitchFamily="18" charset="0"/>
                <a:cs typeface="Times New Roman" pitchFamily="18" charset="0"/>
              </a:rPr>
              <a:t>esp</a:t>
            </a:r>
            <a:r>
              <a:rPr lang="en-US" b="1" dirty="0" err="1">
                <a:latin typeface="Times New Roman" panose="02020603050405020304" pitchFamily="18" charset="0"/>
                <a:cs typeface="Times New Roman" pitchFamily="18" charset="0"/>
              </a:rPr>
              <a:t>H</a:t>
            </a:r>
            <a:r>
              <a:rPr lang="en-US" b="1" dirty="0">
                <a:latin typeface="Times New Roman" panose="02020603050405020304" pitchFamily="18" charset="0"/>
                <a:cs typeface="Times New Roman" pitchFamily="18" charset="0"/>
              </a:rPr>
              <a:t>/pEspH</a:t>
            </a:r>
            <a:r>
              <a:rPr lang="en-US" b="1" i="1" baseline="-25000" dirty="0">
                <a:latin typeface="Times New Roman" panose="02020603050405020304" pitchFamily="18" charset="0"/>
                <a:cs typeface="Times New Roman" pitchFamily="18" charset="0"/>
              </a:rPr>
              <a:t>K41A</a:t>
            </a:r>
            <a:endParaRPr lang="en-US" b="1" baseline="-25000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cxnSp>
        <p:nvCxnSpPr>
          <p:cNvPr id="912" name="Straight Connector 911">
            <a:extLst>
              <a:ext uri="{FF2B5EF4-FFF2-40B4-BE49-F238E27FC236}">
                <a16:creationId xmlns:a16="http://schemas.microsoft.com/office/drawing/2014/main" id="{380381EA-4497-29D2-4F38-2F456278B45C}"/>
              </a:ext>
            </a:extLst>
          </p:cNvPr>
          <p:cNvCxnSpPr>
            <a:cxnSpLocks/>
          </p:cNvCxnSpPr>
          <p:nvPr/>
        </p:nvCxnSpPr>
        <p:spPr>
          <a:xfrm>
            <a:off x="5826337" y="7127275"/>
            <a:ext cx="9974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6" name="Straight Connector 915">
            <a:extLst>
              <a:ext uri="{FF2B5EF4-FFF2-40B4-BE49-F238E27FC236}">
                <a16:creationId xmlns:a16="http://schemas.microsoft.com/office/drawing/2014/main" id="{AB4A7276-3A10-6009-A0F7-98320508EFCE}"/>
              </a:ext>
            </a:extLst>
          </p:cNvPr>
          <p:cNvCxnSpPr>
            <a:cxnSpLocks/>
          </p:cNvCxnSpPr>
          <p:nvPr/>
        </p:nvCxnSpPr>
        <p:spPr>
          <a:xfrm>
            <a:off x="8469494" y="7285315"/>
            <a:ext cx="9974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11D45B2C-4702-438D-8FEF-D683643F340C}"/>
              </a:ext>
            </a:extLst>
          </p:cNvPr>
          <p:cNvSpPr txBox="1"/>
          <p:nvPr/>
        </p:nvSpPr>
        <p:spPr>
          <a:xfrm>
            <a:off x="0" y="0"/>
            <a:ext cx="142218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8a</a:t>
            </a:r>
            <a:endParaRPr lang="en-IL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111F692-B3E7-4881-A6FC-3D9C44ACC24F}"/>
              </a:ext>
            </a:extLst>
          </p:cNvPr>
          <p:cNvSpPr txBox="1"/>
          <p:nvPr/>
        </p:nvSpPr>
        <p:spPr>
          <a:xfrm>
            <a:off x="4856274" y="350635"/>
            <a:ext cx="28867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Times New Roman" panose="02020603050405020304" pitchFamily="18" charset="0"/>
                <a:cs typeface="Times New Roman" pitchFamily="18" charset="0"/>
              </a:rPr>
              <a:t>GFP-Rab8a</a:t>
            </a:r>
            <a:r>
              <a:rPr lang="en-US" sz="2400" b="1" i="1" baseline="-25000" dirty="0">
                <a:latin typeface="Times New Roman" panose="02020603050405020304" pitchFamily="18" charset="0"/>
                <a:cs typeface="Times New Roman" pitchFamily="18" charset="0"/>
              </a:rPr>
              <a:t>wt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586C4679-0540-4F39-4EE8-45BA68C4692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16691" y="1217829"/>
            <a:ext cx="5760000" cy="276067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E10EE5E7-4B12-64C6-B81F-6AEA871AF49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04898" y="4417824"/>
            <a:ext cx="5760000" cy="2709451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56204DFF-D539-3546-3E10-7BB536722C0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46956" y="1217829"/>
            <a:ext cx="5760000" cy="27661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678619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9307</TotalTime>
  <Words>149</Words>
  <Application>Microsoft Office PowerPoint</Application>
  <PresentationFormat>Custom</PresentationFormat>
  <Paragraphs>65</Paragraphs>
  <Slides>1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2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psita</dc:creator>
  <cp:lastModifiedBy>Benjamin Aroeti</cp:lastModifiedBy>
  <cp:revision>266</cp:revision>
  <cp:lastPrinted>2023-07-31T09:33:54Z</cp:lastPrinted>
  <dcterms:created xsi:type="dcterms:W3CDTF">2021-01-12T08:40:27Z</dcterms:created>
  <dcterms:modified xsi:type="dcterms:W3CDTF">2024-09-17T14:47:06Z</dcterms:modified>
</cp:coreProperties>
</file>